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  <p:sldId id="268" r:id="rId3"/>
    <p:sldId id="264" r:id="rId4"/>
    <p:sldId id="263" r:id="rId5"/>
    <p:sldId id="266" r:id="rId6"/>
    <p:sldId id="265" r:id="rId7"/>
  </p:sldIdLst>
  <p:sldSz cx="6858000" cy="9906000" type="A4"/>
  <p:notesSz cx="6797675" cy="9982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0099"/>
    <a:srgbClr val="66FF99"/>
    <a:srgbClr val="99FFCC"/>
    <a:srgbClr val="3399FF"/>
    <a:srgbClr val="33CCFF"/>
    <a:srgbClr val="CCCC00"/>
    <a:srgbClr val="3FBF7F"/>
    <a:srgbClr val="7FFF7F"/>
    <a:srgbClr val="FFFF7F"/>
    <a:srgbClr val="7FFF3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94" autoAdjust="0"/>
    <p:restoredTop sz="94660"/>
  </p:normalViewPr>
  <p:slideViewPr>
    <p:cSldViewPr snapToGrid="0">
      <p:cViewPr varScale="1">
        <p:scale>
          <a:sx n="89" d="100"/>
          <a:sy n="89" d="100"/>
        </p:scale>
        <p:origin x="331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tri-dmf.int.tri.edu.au\data\mater_research\RG17.%20Human%20Genetics%20-%20KS\DAH\Chicken%20data\Chicken%20family%20study\Spleen%20analysis\Spleen%20RNAseq%20data-for%20Graphi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tri-dmf.int.tri.edu.au\data\mater_research\RG17.%20Human%20Genetics%20-%20KS\DAH\Chicken%20data\Chicken%20family%20study\Spleen%20analysis\Spleen%20RNAseq%20data-for%20Graphi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tri-dmf.int.tri.edu.au\data\mater_research\RG17.%20Human%20Genetics%20-%20KS\DAH\Chicken%20data\Chicken%20family%20study\Spleen%20analysis\Spleen%20RNAseq%20data-for%20Graphia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tri-dmf.int.tri.edu.au\data\mater_research\RG17.%20Human%20Genetics%20-%20KS\DAH\Chicken%20data\Chicken%20family%20study\Spleen%20analysis\Spleen%20RNAseq%20data-for%20Graphia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tri-dmf.int.tri.edu.au\data\mater_research\RG17.%20Human%20Genetics%20-%20KS\DAH\Chicken%20data\Chicken%20family%20study\Spleen%20analysis\Spleen%20RNAseq%20data-for%20Graphia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/tri-dmf.int.tri.edu.au\data\mater_research\RG17.%20Human%20Genetics%20-%20KS\DAH\Chicken%20data\Chicken%20family%20study\Spleen%20analysis\Spleen%20RNAseq%20data-for%20Graphia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/tri-dmf.int.tri.edu.au\data\mater_research\RG17.%20Human%20Genetics%20-%20KS\DAH\Chicken%20data\Chicken%20family%20study\Spleen%20analysis\Spleen%20RNAseq%20data-for%20Graphia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/tri-dmf.int.tri.edu.au\data\mater_research\RG17.%20Human%20Genetics%20-%20KS\DAH\Chicken%20data\Chicken%20family%20study\BMDM%20analysis\Chicken%20BMDM%20LPS%20set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AU"/>
              <a:t>MYL12A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val>
            <c:numRef>
              <c:f>'Spleen RNAseq data-filtered'!$G$9621:$W$9621</c:f>
              <c:numCache>
                <c:formatCode>General</c:formatCode>
                <c:ptCount val="17"/>
                <c:pt idx="0">
                  <c:v>303.37599999999998</c:v>
                </c:pt>
                <c:pt idx="1">
                  <c:v>263.67</c:v>
                </c:pt>
                <c:pt idx="2">
                  <c:v>464.47800000000001</c:v>
                </c:pt>
                <c:pt idx="3">
                  <c:v>303.86</c:v>
                </c:pt>
                <c:pt idx="4">
                  <c:v>206.93100000000001</c:v>
                </c:pt>
                <c:pt idx="5">
                  <c:v>533.01599999999996</c:v>
                </c:pt>
                <c:pt idx="6">
                  <c:v>449.726</c:v>
                </c:pt>
                <c:pt idx="7">
                  <c:v>500.43700000000001</c:v>
                </c:pt>
                <c:pt idx="8">
                  <c:v>327.46899999999999</c:v>
                </c:pt>
                <c:pt idx="9">
                  <c:v>522.14</c:v>
                </c:pt>
                <c:pt idx="10">
                  <c:v>251.02099999999999</c:v>
                </c:pt>
                <c:pt idx="11">
                  <c:v>328.04399999999998</c:v>
                </c:pt>
                <c:pt idx="12">
                  <c:v>0</c:v>
                </c:pt>
                <c:pt idx="13">
                  <c:v>360.36399999999998</c:v>
                </c:pt>
                <c:pt idx="14">
                  <c:v>0</c:v>
                </c:pt>
                <c:pt idx="15">
                  <c:v>416.11099999999999</c:v>
                </c:pt>
                <c:pt idx="16">
                  <c:v>425.434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7AD-48BB-ABE1-6DDCDC628DD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27"/>
        <c:axId val="670062776"/>
        <c:axId val="670063104"/>
      </c:barChart>
      <c:catAx>
        <c:axId val="6700627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70063104"/>
        <c:crosses val="autoZero"/>
        <c:auto val="1"/>
        <c:lblAlgn val="ctr"/>
        <c:lblOffset val="100"/>
        <c:noMultiLvlLbl val="0"/>
      </c:catAx>
      <c:valAx>
        <c:axId val="6700631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70062776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PTX3</a:t>
            </a:r>
          </a:p>
        </c:rich>
      </c:tx>
      <c:layout>
        <c:manualLayout>
          <c:xMode val="edge"/>
          <c:yMode val="edge"/>
          <c:x val="0.45840297388986712"/>
          <c:y val="4.499993117528582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5B52-4777-A366-A0B9320DBE30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5B52-4777-A366-A0B9320DBE30}"/>
              </c:ext>
            </c:extLst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5B52-4777-A366-A0B9320DBE30}"/>
              </c:ext>
            </c:extLst>
          </c:dPt>
          <c:dPt>
            <c:idx val="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5B52-4777-A366-A0B9320DBE30}"/>
              </c:ext>
            </c:extLst>
          </c:dPt>
          <c:dPt>
            <c:idx val="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5B52-4777-A366-A0B9320DBE30}"/>
              </c:ext>
            </c:extLst>
          </c:dPt>
          <c:dPt>
            <c:idx val="1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5B52-4777-A366-A0B9320DBE30}"/>
              </c:ext>
            </c:extLst>
          </c:dPt>
          <c:dPt>
            <c:idx val="1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5B52-4777-A366-A0B9320DBE30}"/>
              </c:ext>
            </c:extLst>
          </c:dPt>
          <c:dPt>
            <c:idx val="1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5B52-4777-A366-A0B9320DBE30}"/>
              </c:ext>
            </c:extLst>
          </c:dPt>
          <c:dPt>
            <c:idx val="1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5B52-4777-A366-A0B9320DBE30}"/>
              </c:ext>
            </c:extLst>
          </c:dPt>
          <c:dPt>
            <c:idx val="1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3-5B52-4777-A366-A0B9320DBE30}"/>
              </c:ext>
            </c:extLst>
          </c:dPt>
          <c:dPt>
            <c:idx val="2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5-5B52-4777-A366-A0B9320DBE30}"/>
              </c:ext>
            </c:extLst>
          </c:dPt>
          <c:dPt>
            <c:idx val="2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7-5B52-4777-A366-A0B9320DBE30}"/>
              </c:ext>
            </c:extLst>
          </c:dPt>
          <c:dPt>
            <c:idx val="2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9-5B52-4777-A366-A0B9320DBE30}"/>
              </c:ext>
            </c:extLst>
          </c:dPt>
          <c:dPt>
            <c:idx val="2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B-5B52-4777-A366-A0B9320DBE30}"/>
              </c:ext>
            </c:extLst>
          </c:dPt>
          <c:dPt>
            <c:idx val="2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D-5B52-4777-A366-A0B9320DBE30}"/>
              </c:ext>
            </c:extLst>
          </c:dPt>
          <c:dPt>
            <c:idx val="3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F-5B52-4777-A366-A0B9320DBE30}"/>
              </c:ext>
            </c:extLst>
          </c:dPt>
          <c:dPt>
            <c:idx val="3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1-5B52-4777-A366-A0B9320DBE30}"/>
              </c:ext>
            </c:extLst>
          </c:dPt>
          <c:dPt>
            <c:idx val="3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3-5B52-4777-A366-A0B9320DBE30}"/>
              </c:ext>
            </c:extLst>
          </c:dPt>
          <c:dPt>
            <c:idx val="3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5-5B52-4777-A366-A0B9320DBE30}"/>
              </c:ext>
            </c:extLst>
          </c:dPt>
          <c:dPt>
            <c:idx val="3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7-5B52-4777-A366-A0B9320DBE30}"/>
              </c:ext>
            </c:extLst>
          </c:dPt>
          <c:dPt>
            <c:idx val="4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9-5B52-4777-A366-A0B9320DBE30}"/>
              </c:ext>
            </c:extLst>
          </c:dPt>
          <c:dPt>
            <c:idx val="4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B-5B52-4777-A366-A0B9320DBE30}"/>
              </c:ext>
            </c:extLst>
          </c:dPt>
          <c:dPt>
            <c:idx val="4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D-5B52-4777-A366-A0B9320DBE30}"/>
              </c:ext>
            </c:extLst>
          </c:dPt>
          <c:dPt>
            <c:idx val="4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F-5B52-4777-A366-A0B9320DBE30}"/>
              </c:ext>
            </c:extLst>
          </c:dPt>
          <c:dPt>
            <c:idx val="4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1-5B52-4777-A366-A0B9320DBE30}"/>
              </c:ext>
            </c:extLst>
          </c:dPt>
          <c:dPt>
            <c:idx val="5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3-5B52-4777-A366-A0B9320DBE30}"/>
              </c:ext>
            </c:extLst>
          </c:dPt>
          <c:dPt>
            <c:idx val="5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5-5B52-4777-A366-A0B9320DBE30}"/>
              </c:ext>
            </c:extLst>
          </c:dPt>
          <c:dPt>
            <c:idx val="5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7-5B52-4777-A366-A0B9320DBE30}"/>
              </c:ext>
            </c:extLst>
          </c:dPt>
          <c:cat>
            <c:strRef>
              <c:f>Sheet1!$B$1:$BE$1</c:f>
              <c:strCache>
                <c:ptCount val="56"/>
                <c:pt idx="0">
                  <c:v>B510</c:v>
                </c:pt>
                <c:pt idx="1">
                  <c:v>B510</c:v>
                </c:pt>
                <c:pt idx="2">
                  <c:v>B459</c:v>
                </c:pt>
                <c:pt idx="3">
                  <c:v>B459</c:v>
                </c:pt>
                <c:pt idx="4">
                  <c:v>B512</c:v>
                </c:pt>
                <c:pt idx="5">
                  <c:v>B512</c:v>
                </c:pt>
                <c:pt idx="6">
                  <c:v>B513</c:v>
                </c:pt>
                <c:pt idx="7">
                  <c:v>B513</c:v>
                </c:pt>
                <c:pt idx="8">
                  <c:v>B540</c:v>
                </c:pt>
                <c:pt idx="9">
                  <c:v>B540</c:v>
                </c:pt>
                <c:pt idx="10">
                  <c:v>B541</c:v>
                </c:pt>
                <c:pt idx="11">
                  <c:v>B541</c:v>
                </c:pt>
                <c:pt idx="12">
                  <c:v>B542</c:v>
                </c:pt>
                <c:pt idx="13">
                  <c:v>B542</c:v>
                </c:pt>
                <c:pt idx="14">
                  <c:v>B643</c:v>
                </c:pt>
                <c:pt idx="15">
                  <c:v>B643</c:v>
                </c:pt>
                <c:pt idx="16">
                  <c:v>B664</c:v>
                </c:pt>
                <c:pt idx="17">
                  <c:v>B664</c:v>
                </c:pt>
                <c:pt idx="18">
                  <c:v>B666</c:v>
                </c:pt>
                <c:pt idx="19">
                  <c:v>B666</c:v>
                </c:pt>
                <c:pt idx="20">
                  <c:v>B699</c:v>
                </c:pt>
                <c:pt idx="21">
                  <c:v>B699</c:v>
                </c:pt>
                <c:pt idx="22">
                  <c:v>B700</c:v>
                </c:pt>
                <c:pt idx="23">
                  <c:v>B700</c:v>
                </c:pt>
                <c:pt idx="24">
                  <c:v>B701</c:v>
                </c:pt>
                <c:pt idx="25">
                  <c:v>B701</c:v>
                </c:pt>
                <c:pt idx="26">
                  <c:v>B702</c:v>
                </c:pt>
                <c:pt idx="27">
                  <c:v>B702</c:v>
                </c:pt>
                <c:pt idx="28">
                  <c:v>B703</c:v>
                </c:pt>
                <c:pt idx="29">
                  <c:v>B703</c:v>
                </c:pt>
                <c:pt idx="30">
                  <c:v>B4292</c:v>
                </c:pt>
                <c:pt idx="31">
                  <c:v>B4292</c:v>
                </c:pt>
                <c:pt idx="32">
                  <c:v>B4293</c:v>
                </c:pt>
                <c:pt idx="33">
                  <c:v>B4293</c:v>
                </c:pt>
                <c:pt idx="34">
                  <c:v>B476</c:v>
                </c:pt>
                <c:pt idx="35">
                  <c:v>B476</c:v>
                </c:pt>
                <c:pt idx="36">
                  <c:v>B477</c:v>
                </c:pt>
                <c:pt idx="37">
                  <c:v>B477</c:v>
                </c:pt>
                <c:pt idx="38">
                  <c:v>B528</c:v>
                </c:pt>
                <c:pt idx="39">
                  <c:v>B528</c:v>
                </c:pt>
                <c:pt idx="40">
                  <c:v>B613</c:v>
                </c:pt>
                <c:pt idx="41">
                  <c:v>B613</c:v>
                </c:pt>
                <c:pt idx="42">
                  <c:v>B614</c:v>
                </c:pt>
                <c:pt idx="43">
                  <c:v>B614</c:v>
                </c:pt>
                <c:pt idx="44">
                  <c:v>B628</c:v>
                </c:pt>
                <c:pt idx="45">
                  <c:v>B628</c:v>
                </c:pt>
                <c:pt idx="46">
                  <c:v>B463</c:v>
                </c:pt>
                <c:pt idx="47">
                  <c:v>B463</c:v>
                </c:pt>
                <c:pt idx="48">
                  <c:v>B514</c:v>
                </c:pt>
                <c:pt idx="49">
                  <c:v>B514</c:v>
                </c:pt>
                <c:pt idx="50">
                  <c:v>B606</c:v>
                </c:pt>
                <c:pt idx="51">
                  <c:v>B606</c:v>
                </c:pt>
                <c:pt idx="52">
                  <c:v>B657</c:v>
                </c:pt>
                <c:pt idx="53">
                  <c:v>B657</c:v>
                </c:pt>
                <c:pt idx="54">
                  <c:v>B503</c:v>
                </c:pt>
                <c:pt idx="55">
                  <c:v>B503</c:v>
                </c:pt>
              </c:strCache>
            </c:strRef>
          </c:cat>
          <c:val>
            <c:numRef>
              <c:f>Sheet1!$B$2:$BE$2</c:f>
              <c:numCache>
                <c:formatCode>General</c:formatCode>
                <c:ptCount val="56"/>
                <c:pt idx="0">
                  <c:v>302.20299999999997</c:v>
                </c:pt>
                <c:pt idx="1">
                  <c:v>520.25</c:v>
                </c:pt>
                <c:pt idx="2">
                  <c:v>46.314</c:v>
                </c:pt>
                <c:pt idx="3">
                  <c:v>43.536000000000001</c:v>
                </c:pt>
                <c:pt idx="4">
                  <c:v>56.74</c:v>
                </c:pt>
                <c:pt idx="5">
                  <c:v>76.650000000000006</c:v>
                </c:pt>
                <c:pt idx="6">
                  <c:v>40.533000000000001</c:v>
                </c:pt>
                <c:pt idx="7">
                  <c:v>66.727999999999994</c:v>
                </c:pt>
                <c:pt idx="8">
                  <c:v>50.709000000000003</c:v>
                </c:pt>
                <c:pt idx="9">
                  <c:v>46.405000000000001</c:v>
                </c:pt>
                <c:pt idx="10">
                  <c:v>18.187000000000001</c:v>
                </c:pt>
                <c:pt idx="11">
                  <c:v>13.212</c:v>
                </c:pt>
                <c:pt idx="12">
                  <c:v>18.199000000000002</c:v>
                </c:pt>
                <c:pt idx="13">
                  <c:v>53.570999999999998</c:v>
                </c:pt>
                <c:pt idx="14">
                  <c:v>49.49</c:v>
                </c:pt>
                <c:pt idx="15">
                  <c:v>147.69399999999999</c:v>
                </c:pt>
                <c:pt idx="16">
                  <c:v>23.908999999999999</c:v>
                </c:pt>
                <c:pt idx="17">
                  <c:v>23.931000000000001</c:v>
                </c:pt>
                <c:pt idx="18">
                  <c:v>33.786000000000001</c:v>
                </c:pt>
                <c:pt idx="19">
                  <c:v>119.905</c:v>
                </c:pt>
                <c:pt idx="20">
                  <c:v>21.722000000000001</c:v>
                </c:pt>
                <c:pt idx="21">
                  <c:v>23.488</c:v>
                </c:pt>
                <c:pt idx="22">
                  <c:v>17.707999999999998</c:v>
                </c:pt>
                <c:pt idx="23">
                  <c:v>21.741</c:v>
                </c:pt>
                <c:pt idx="24">
                  <c:v>26.044</c:v>
                </c:pt>
                <c:pt idx="25">
                  <c:v>43.320999999999998</c:v>
                </c:pt>
                <c:pt idx="26">
                  <c:v>19.902000000000001</c:v>
                </c:pt>
                <c:pt idx="27">
                  <c:v>50.146000000000001</c:v>
                </c:pt>
                <c:pt idx="28">
                  <c:v>19.02</c:v>
                </c:pt>
                <c:pt idx="29">
                  <c:v>59.548000000000002</c:v>
                </c:pt>
                <c:pt idx="30">
                  <c:v>72.947999999999993</c:v>
                </c:pt>
                <c:pt idx="31">
                  <c:v>214.50399999999999</c:v>
                </c:pt>
                <c:pt idx="32">
                  <c:v>7.0780000000000003</c:v>
                </c:pt>
                <c:pt idx="33">
                  <c:v>12.311999999999999</c:v>
                </c:pt>
                <c:pt idx="34">
                  <c:v>14.504</c:v>
                </c:pt>
                <c:pt idx="35">
                  <c:v>24.2</c:v>
                </c:pt>
                <c:pt idx="36">
                  <c:v>77.995999999999995</c:v>
                </c:pt>
                <c:pt idx="37">
                  <c:v>46.962000000000003</c:v>
                </c:pt>
                <c:pt idx="38">
                  <c:v>9.5429999999999993</c:v>
                </c:pt>
                <c:pt idx="39">
                  <c:v>5.9980000000000002</c:v>
                </c:pt>
                <c:pt idx="40">
                  <c:v>45.970999999999997</c:v>
                </c:pt>
                <c:pt idx="41">
                  <c:v>88.747</c:v>
                </c:pt>
                <c:pt idx="42">
                  <c:v>115.268</c:v>
                </c:pt>
                <c:pt idx="43">
                  <c:v>77.474999999999994</c:v>
                </c:pt>
                <c:pt idx="44">
                  <c:v>83.906999999999996</c:v>
                </c:pt>
                <c:pt idx="45">
                  <c:v>129.816</c:v>
                </c:pt>
                <c:pt idx="46">
                  <c:v>373.38799999999998</c:v>
                </c:pt>
                <c:pt idx="47">
                  <c:v>415.30099999999999</c:v>
                </c:pt>
                <c:pt idx="48">
                  <c:v>153.922</c:v>
                </c:pt>
                <c:pt idx="49">
                  <c:v>252.71299999999999</c:v>
                </c:pt>
                <c:pt idx="50">
                  <c:v>229.98599999999999</c:v>
                </c:pt>
                <c:pt idx="51">
                  <c:v>368.73</c:v>
                </c:pt>
                <c:pt idx="52">
                  <c:v>2.7679999999999998</c:v>
                </c:pt>
                <c:pt idx="53">
                  <c:v>9.44</c:v>
                </c:pt>
                <c:pt idx="54">
                  <c:v>6.2770000000000001</c:v>
                </c:pt>
                <c:pt idx="55">
                  <c:v>5.4349999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8-5B52-4777-A366-A0B9320DBE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"/>
        <c:overlap val="-27"/>
        <c:axId val="843511712"/>
        <c:axId val="843512040"/>
      </c:barChart>
      <c:catAx>
        <c:axId val="8435117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43512040"/>
        <c:crosses val="autoZero"/>
        <c:auto val="1"/>
        <c:lblAlgn val="ctr"/>
        <c:lblOffset val="100"/>
        <c:noMultiLvlLbl val="0"/>
      </c:catAx>
      <c:valAx>
        <c:axId val="8435120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43511712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CSF3</a:t>
            </a:r>
          </a:p>
        </c:rich>
      </c:tx>
      <c:layout>
        <c:manualLayout>
          <c:xMode val="edge"/>
          <c:yMode val="edge"/>
          <c:x val="0.43777475072999833"/>
          <c:y val="3.611104436021128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313C-4811-9C5B-D9DA71BB95D7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313C-4811-9C5B-D9DA71BB95D7}"/>
              </c:ext>
            </c:extLst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313C-4811-9C5B-D9DA71BB95D7}"/>
              </c:ext>
            </c:extLst>
          </c:dPt>
          <c:dPt>
            <c:idx val="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313C-4811-9C5B-D9DA71BB95D7}"/>
              </c:ext>
            </c:extLst>
          </c:dPt>
          <c:dPt>
            <c:idx val="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313C-4811-9C5B-D9DA71BB95D7}"/>
              </c:ext>
            </c:extLst>
          </c:dPt>
          <c:dPt>
            <c:idx val="1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313C-4811-9C5B-D9DA71BB95D7}"/>
              </c:ext>
            </c:extLst>
          </c:dPt>
          <c:dPt>
            <c:idx val="1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313C-4811-9C5B-D9DA71BB95D7}"/>
              </c:ext>
            </c:extLst>
          </c:dPt>
          <c:dPt>
            <c:idx val="1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313C-4811-9C5B-D9DA71BB95D7}"/>
              </c:ext>
            </c:extLst>
          </c:dPt>
          <c:dPt>
            <c:idx val="1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313C-4811-9C5B-D9DA71BB95D7}"/>
              </c:ext>
            </c:extLst>
          </c:dPt>
          <c:dPt>
            <c:idx val="1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3-313C-4811-9C5B-D9DA71BB95D7}"/>
              </c:ext>
            </c:extLst>
          </c:dPt>
          <c:dPt>
            <c:idx val="2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5-313C-4811-9C5B-D9DA71BB95D7}"/>
              </c:ext>
            </c:extLst>
          </c:dPt>
          <c:dPt>
            <c:idx val="2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7-313C-4811-9C5B-D9DA71BB95D7}"/>
              </c:ext>
            </c:extLst>
          </c:dPt>
          <c:dPt>
            <c:idx val="2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9-313C-4811-9C5B-D9DA71BB95D7}"/>
              </c:ext>
            </c:extLst>
          </c:dPt>
          <c:dPt>
            <c:idx val="2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B-313C-4811-9C5B-D9DA71BB95D7}"/>
              </c:ext>
            </c:extLst>
          </c:dPt>
          <c:dPt>
            <c:idx val="2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D-313C-4811-9C5B-D9DA71BB95D7}"/>
              </c:ext>
            </c:extLst>
          </c:dPt>
          <c:dPt>
            <c:idx val="3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F-313C-4811-9C5B-D9DA71BB95D7}"/>
              </c:ext>
            </c:extLst>
          </c:dPt>
          <c:dPt>
            <c:idx val="3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1-313C-4811-9C5B-D9DA71BB95D7}"/>
              </c:ext>
            </c:extLst>
          </c:dPt>
          <c:dPt>
            <c:idx val="3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3-313C-4811-9C5B-D9DA71BB95D7}"/>
              </c:ext>
            </c:extLst>
          </c:dPt>
          <c:dPt>
            <c:idx val="3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5-313C-4811-9C5B-D9DA71BB95D7}"/>
              </c:ext>
            </c:extLst>
          </c:dPt>
          <c:dPt>
            <c:idx val="3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7-313C-4811-9C5B-D9DA71BB95D7}"/>
              </c:ext>
            </c:extLst>
          </c:dPt>
          <c:dPt>
            <c:idx val="4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9-313C-4811-9C5B-D9DA71BB95D7}"/>
              </c:ext>
            </c:extLst>
          </c:dPt>
          <c:dPt>
            <c:idx val="4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B-313C-4811-9C5B-D9DA71BB95D7}"/>
              </c:ext>
            </c:extLst>
          </c:dPt>
          <c:dPt>
            <c:idx val="4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D-313C-4811-9C5B-D9DA71BB95D7}"/>
              </c:ext>
            </c:extLst>
          </c:dPt>
          <c:dPt>
            <c:idx val="4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F-313C-4811-9C5B-D9DA71BB95D7}"/>
              </c:ext>
            </c:extLst>
          </c:dPt>
          <c:dPt>
            <c:idx val="4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1-313C-4811-9C5B-D9DA71BB95D7}"/>
              </c:ext>
            </c:extLst>
          </c:dPt>
          <c:dPt>
            <c:idx val="5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3-313C-4811-9C5B-D9DA71BB95D7}"/>
              </c:ext>
            </c:extLst>
          </c:dPt>
          <c:dPt>
            <c:idx val="5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5-313C-4811-9C5B-D9DA71BB95D7}"/>
              </c:ext>
            </c:extLst>
          </c:dPt>
          <c:dPt>
            <c:idx val="5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7-313C-4811-9C5B-D9DA71BB95D7}"/>
              </c:ext>
            </c:extLst>
          </c:dPt>
          <c:cat>
            <c:strRef>
              <c:f>Sheet1!$B$1:$BE$1</c:f>
              <c:strCache>
                <c:ptCount val="56"/>
                <c:pt idx="0">
                  <c:v>B510</c:v>
                </c:pt>
                <c:pt idx="1">
                  <c:v>B510</c:v>
                </c:pt>
                <c:pt idx="2">
                  <c:v>B459</c:v>
                </c:pt>
                <c:pt idx="3">
                  <c:v>B459</c:v>
                </c:pt>
                <c:pt idx="4">
                  <c:v>B512</c:v>
                </c:pt>
                <c:pt idx="5">
                  <c:v>B512</c:v>
                </c:pt>
                <c:pt idx="6">
                  <c:v>B513</c:v>
                </c:pt>
                <c:pt idx="7">
                  <c:v>B513</c:v>
                </c:pt>
                <c:pt idx="8">
                  <c:v>B540</c:v>
                </c:pt>
                <c:pt idx="9">
                  <c:v>B540</c:v>
                </c:pt>
                <c:pt idx="10">
                  <c:v>B541</c:v>
                </c:pt>
                <c:pt idx="11">
                  <c:v>B541</c:v>
                </c:pt>
                <c:pt idx="12">
                  <c:v>B542</c:v>
                </c:pt>
                <c:pt idx="13">
                  <c:v>B542</c:v>
                </c:pt>
                <c:pt idx="14">
                  <c:v>B643</c:v>
                </c:pt>
                <c:pt idx="15">
                  <c:v>B643</c:v>
                </c:pt>
                <c:pt idx="16">
                  <c:v>B664</c:v>
                </c:pt>
                <c:pt idx="17">
                  <c:v>B664</c:v>
                </c:pt>
                <c:pt idx="18">
                  <c:v>B666</c:v>
                </c:pt>
                <c:pt idx="19">
                  <c:v>B666</c:v>
                </c:pt>
                <c:pt idx="20">
                  <c:v>B699</c:v>
                </c:pt>
                <c:pt idx="21">
                  <c:v>B699</c:v>
                </c:pt>
                <c:pt idx="22">
                  <c:v>B700</c:v>
                </c:pt>
                <c:pt idx="23">
                  <c:v>B700</c:v>
                </c:pt>
                <c:pt idx="24">
                  <c:v>B701</c:v>
                </c:pt>
                <c:pt idx="25">
                  <c:v>B701</c:v>
                </c:pt>
                <c:pt idx="26">
                  <c:v>B702</c:v>
                </c:pt>
                <c:pt idx="27">
                  <c:v>B702</c:v>
                </c:pt>
                <c:pt idx="28">
                  <c:v>B703</c:v>
                </c:pt>
                <c:pt idx="29">
                  <c:v>B703</c:v>
                </c:pt>
                <c:pt idx="30">
                  <c:v>B4292</c:v>
                </c:pt>
                <c:pt idx="31">
                  <c:v>B4292</c:v>
                </c:pt>
                <c:pt idx="32">
                  <c:v>B4293</c:v>
                </c:pt>
                <c:pt idx="33">
                  <c:v>B4293</c:v>
                </c:pt>
                <c:pt idx="34">
                  <c:v>B476</c:v>
                </c:pt>
                <c:pt idx="35">
                  <c:v>B476</c:v>
                </c:pt>
                <c:pt idx="36">
                  <c:v>B477</c:v>
                </c:pt>
                <c:pt idx="37">
                  <c:v>B477</c:v>
                </c:pt>
                <c:pt idx="38">
                  <c:v>B528</c:v>
                </c:pt>
                <c:pt idx="39">
                  <c:v>B528</c:v>
                </c:pt>
                <c:pt idx="40">
                  <c:v>B613</c:v>
                </c:pt>
                <c:pt idx="41">
                  <c:v>B613</c:v>
                </c:pt>
                <c:pt idx="42">
                  <c:v>B614</c:v>
                </c:pt>
                <c:pt idx="43">
                  <c:v>B614</c:v>
                </c:pt>
                <c:pt idx="44">
                  <c:v>B628</c:v>
                </c:pt>
                <c:pt idx="45">
                  <c:v>B628</c:v>
                </c:pt>
                <c:pt idx="46">
                  <c:v>B463</c:v>
                </c:pt>
                <c:pt idx="47">
                  <c:v>B463</c:v>
                </c:pt>
                <c:pt idx="48">
                  <c:v>B514</c:v>
                </c:pt>
                <c:pt idx="49">
                  <c:v>B514</c:v>
                </c:pt>
                <c:pt idx="50">
                  <c:v>B606</c:v>
                </c:pt>
                <c:pt idx="51">
                  <c:v>B606</c:v>
                </c:pt>
                <c:pt idx="52">
                  <c:v>B657</c:v>
                </c:pt>
                <c:pt idx="53">
                  <c:v>B657</c:v>
                </c:pt>
                <c:pt idx="54">
                  <c:v>B503</c:v>
                </c:pt>
                <c:pt idx="55">
                  <c:v>B503</c:v>
                </c:pt>
              </c:strCache>
            </c:strRef>
          </c:cat>
          <c:val>
            <c:numRef>
              <c:f>Sheet1!$B$8:$BE$8</c:f>
              <c:numCache>
                <c:formatCode>General</c:formatCode>
                <c:ptCount val="56"/>
                <c:pt idx="0">
                  <c:v>0.33100000000000002</c:v>
                </c:pt>
                <c:pt idx="1">
                  <c:v>358.46899999999999</c:v>
                </c:pt>
                <c:pt idx="2">
                  <c:v>0</c:v>
                </c:pt>
                <c:pt idx="3">
                  <c:v>33.426000000000002</c:v>
                </c:pt>
                <c:pt idx="4">
                  <c:v>0.13200000000000001</c:v>
                </c:pt>
                <c:pt idx="5">
                  <c:v>6.3120000000000003</c:v>
                </c:pt>
                <c:pt idx="6">
                  <c:v>0.16300000000000001</c:v>
                </c:pt>
                <c:pt idx="7">
                  <c:v>309.87</c:v>
                </c:pt>
                <c:pt idx="8">
                  <c:v>0.25800000000000001</c:v>
                </c:pt>
                <c:pt idx="9">
                  <c:v>109.40600000000001</c:v>
                </c:pt>
                <c:pt idx="10">
                  <c:v>92.15</c:v>
                </c:pt>
                <c:pt idx="11">
                  <c:v>120.834</c:v>
                </c:pt>
                <c:pt idx="12">
                  <c:v>8.5000000000000006E-2</c:v>
                </c:pt>
                <c:pt idx="13">
                  <c:v>25.954999999999998</c:v>
                </c:pt>
                <c:pt idx="14">
                  <c:v>0</c:v>
                </c:pt>
                <c:pt idx="15">
                  <c:v>3.585</c:v>
                </c:pt>
                <c:pt idx="16">
                  <c:v>0.312</c:v>
                </c:pt>
                <c:pt idx="17">
                  <c:v>125.60299999999999</c:v>
                </c:pt>
                <c:pt idx="18">
                  <c:v>10.164999999999999</c:v>
                </c:pt>
                <c:pt idx="19">
                  <c:v>48.374000000000002</c:v>
                </c:pt>
                <c:pt idx="20">
                  <c:v>0.20200000000000001</c:v>
                </c:pt>
                <c:pt idx="21">
                  <c:v>163.01</c:v>
                </c:pt>
                <c:pt idx="22">
                  <c:v>0.126</c:v>
                </c:pt>
                <c:pt idx="23">
                  <c:v>31.75</c:v>
                </c:pt>
                <c:pt idx="24">
                  <c:v>0.157</c:v>
                </c:pt>
                <c:pt idx="25">
                  <c:v>109.60599999999999</c:v>
                </c:pt>
                <c:pt idx="26">
                  <c:v>0.128</c:v>
                </c:pt>
                <c:pt idx="27">
                  <c:v>25.571000000000002</c:v>
                </c:pt>
                <c:pt idx="28">
                  <c:v>5.8000000000000003E-2</c:v>
                </c:pt>
                <c:pt idx="29">
                  <c:v>18.635000000000002</c:v>
                </c:pt>
                <c:pt idx="30">
                  <c:v>0.13500000000000001</c:v>
                </c:pt>
                <c:pt idx="31">
                  <c:v>10.788</c:v>
                </c:pt>
                <c:pt idx="32">
                  <c:v>0.214</c:v>
                </c:pt>
                <c:pt idx="33">
                  <c:v>47.564</c:v>
                </c:pt>
                <c:pt idx="34">
                  <c:v>0.21299999999999999</c:v>
                </c:pt>
                <c:pt idx="35">
                  <c:v>715.322</c:v>
                </c:pt>
                <c:pt idx="36">
                  <c:v>2.5999999999999999E-2</c:v>
                </c:pt>
                <c:pt idx="37">
                  <c:v>2.63</c:v>
                </c:pt>
                <c:pt idx="38">
                  <c:v>0.105</c:v>
                </c:pt>
                <c:pt idx="39">
                  <c:v>2.0169999999999999</c:v>
                </c:pt>
                <c:pt idx="40">
                  <c:v>0.106</c:v>
                </c:pt>
                <c:pt idx="41">
                  <c:v>315.35500000000002</c:v>
                </c:pt>
                <c:pt idx="42">
                  <c:v>0.10199999999999999</c:v>
                </c:pt>
                <c:pt idx="43">
                  <c:v>121.667</c:v>
                </c:pt>
                <c:pt idx="44">
                  <c:v>8.1000000000000003E-2</c:v>
                </c:pt>
                <c:pt idx="45">
                  <c:v>11.763999999999999</c:v>
                </c:pt>
                <c:pt idx="46">
                  <c:v>0.16500000000000001</c:v>
                </c:pt>
                <c:pt idx="47">
                  <c:v>1.91</c:v>
                </c:pt>
                <c:pt idx="48">
                  <c:v>1.379</c:v>
                </c:pt>
                <c:pt idx="49">
                  <c:v>244.57300000000001</c:v>
                </c:pt>
                <c:pt idx="50">
                  <c:v>0.499</c:v>
                </c:pt>
                <c:pt idx="51">
                  <c:v>104.20399999999999</c:v>
                </c:pt>
                <c:pt idx="52">
                  <c:v>1.6040000000000001</c:v>
                </c:pt>
                <c:pt idx="53">
                  <c:v>108.791</c:v>
                </c:pt>
                <c:pt idx="54">
                  <c:v>9.9000000000000005E-2</c:v>
                </c:pt>
                <c:pt idx="55">
                  <c:v>79.8640000000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8-313C-4811-9C5B-D9DA71BB95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"/>
        <c:overlap val="-27"/>
        <c:axId val="843511712"/>
        <c:axId val="843512040"/>
      </c:barChart>
      <c:catAx>
        <c:axId val="8435117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43512040"/>
        <c:crosses val="autoZero"/>
        <c:auto val="1"/>
        <c:lblAlgn val="ctr"/>
        <c:lblOffset val="100"/>
        <c:noMultiLvlLbl val="0"/>
      </c:catAx>
      <c:valAx>
        <c:axId val="8435120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43511712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IL8</a:t>
            </a:r>
          </a:p>
        </c:rich>
      </c:tx>
      <c:layout>
        <c:manualLayout>
          <c:xMode val="edge"/>
          <c:yMode val="edge"/>
          <c:x val="0.43777475072999833"/>
          <c:y val="3.611104436021128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EB45-433C-83A8-CBA27359976F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EB45-433C-83A8-CBA27359976F}"/>
              </c:ext>
            </c:extLst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EB45-433C-83A8-CBA27359976F}"/>
              </c:ext>
            </c:extLst>
          </c:dPt>
          <c:dPt>
            <c:idx val="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EB45-433C-83A8-CBA27359976F}"/>
              </c:ext>
            </c:extLst>
          </c:dPt>
          <c:dPt>
            <c:idx val="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EB45-433C-83A8-CBA27359976F}"/>
              </c:ext>
            </c:extLst>
          </c:dPt>
          <c:dPt>
            <c:idx val="1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EB45-433C-83A8-CBA27359976F}"/>
              </c:ext>
            </c:extLst>
          </c:dPt>
          <c:dPt>
            <c:idx val="1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EB45-433C-83A8-CBA27359976F}"/>
              </c:ext>
            </c:extLst>
          </c:dPt>
          <c:dPt>
            <c:idx val="1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EB45-433C-83A8-CBA27359976F}"/>
              </c:ext>
            </c:extLst>
          </c:dPt>
          <c:dPt>
            <c:idx val="1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EB45-433C-83A8-CBA27359976F}"/>
              </c:ext>
            </c:extLst>
          </c:dPt>
          <c:dPt>
            <c:idx val="1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3-EB45-433C-83A8-CBA27359976F}"/>
              </c:ext>
            </c:extLst>
          </c:dPt>
          <c:dPt>
            <c:idx val="2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5-EB45-433C-83A8-CBA27359976F}"/>
              </c:ext>
            </c:extLst>
          </c:dPt>
          <c:dPt>
            <c:idx val="2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7-EB45-433C-83A8-CBA27359976F}"/>
              </c:ext>
            </c:extLst>
          </c:dPt>
          <c:dPt>
            <c:idx val="2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9-EB45-433C-83A8-CBA27359976F}"/>
              </c:ext>
            </c:extLst>
          </c:dPt>
          <c:dPt>
            <c:idx val="2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B-EB45-433C-83A8-CBA27359976F}"/>
              </c:ext>
            </c:extLst>
          </c:dPt>
          <c:dPt>
            <c:idx val="2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D-EB45-433C-83A8-CBA27359976F}"/>
              </c:ext>
            </c:extLst>
          </c:dPt>
          <c:dPt>
            <c:idx val="3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F-EB45-433C-83A8-CBA27359976F}"/>
              </c:ext>
            </c:extLst>
          </c:dPt>
          <c:dPt>
            <c:idx val="3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1-EB45-433C-83A8-CBA27359976F}"/>
              </c:ext>
            </c:extLst>
          </c:dPt>
          <c:dPt>
            <c:idx val="3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3-EB45-433C-83A8-CBA27359976F}"/>
              </c:ext>
            </c:extLst>
          </c:dPt>
          <c:dPt>
            <c:idx val="3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5-EB45-433C-83A8-CBA27359976F}"/>
              </c:ext>
            </c:extLst>
          </c:dPt>
          <c:dPt>
            <c:idx val="3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7-EB45-433C-83A8-CBA27359976F}"/>
              </c:ext>
            </c:extLst>
          </c:dPt>
          <c:dPt>
            <c:idx val="4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9-EB45-433C-83A8-CBA27359976F}"/>
              </c:ext>
            </c:extLst>
          </c:dPt>
          <c:dPt>
            <c:idx val="4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B-EB45-433C-83A8-CBA27359976F}"/>
              </c:ext>
            </c:extLst>
          </c:dPt>
          <c:dPt>
            <c:idx val="4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D-EB45-433C-83A8-CBA27359976F}"/>
              </c:ext>
            </c:extLst>
          </c:dPt>
          <c:dPt>
            <c:idx val="4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F-EB45-433C-83A8-CBA27359976F}"/>
              </c:ext>
            </c:extLst>
          </c:dPt>
          <c:dPt>
            <c:idx val="4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1-EB45-433C-83A8-CBA27359976F}"/>
              </c:ext>
            </c:extLst>
          </c:dPt>
          <c:dPt>
            <c:idx val="5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3-EB45-433C-83A8-CBA27359976F}"/>
              </c:ext>
            </c:extLst>
          </c:dPt>
          <c:dPt>
            <c:idx val="5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5-EB45-433C-83A8-CBA27359976F}"/>
              </c:ext>
            </c:extLst>
          </c:dPt>
          <c:dPt>
            <c:idx val="5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7-EB45-433C-83A8-CBA27359976F}"/>
              </c:ext>
            </c:extLst>
          </c:dPt>
          <c:cat>
            <c:strRef>
              <c:f>Sheet1!$B$1:$BE$1</c:f>
              <c:strCache>
                <c:ptCount val="56"/>
                <c:pt idx="0">
                  <c:v>B510</c:v>
                </c:pt>
                <c:pt idx="1">
                  <c:v>B510</c:v>
                </c:pt>
                <c:pt idx="2">
                  <c:v>B459</c:v>
                </c:pt>
                <c:pt idx="3">
                  <c:v>B459</c:v>
                </c:pt>
                <c:pt idx="4">
                  <c:v>B512</c:v>
                </c:pt>
                <c:pt idx="5">
                  <c:v>B512</c:v>
                </c:pt>
                <c:pt idx="6">
                  <c:v>B513</c:v>
                </c:pt>
                <c:pt idx="7">
                  <c:v>B513</c:v>
                </c:pt>
                <c:pt idx="8">
                  <c:v>B540</c:v>
                </c:pt>
                <c:pt idx="9">
                  <c:v>B540</c:v>
                </c:pt>
                <c:pt idx="10">
                  <c:v>B541</c:v>
                </c:pt>
                <c:pt idx="11">
                  <c:v>B541</c:v>
                </c:pt>
                <c:pt idx="12">
                  <c:v>B542</c:v>
                </c:pt>
                <c:pt idx="13">
                  <c:v>B542</c:v>
                </c:pt>
                <c:pt idx="14">
                  <c:v>B643</c:v>
                </c:pt>
                <c:pt idx="15">
                  <c:v>B643</c:v>
                </c:pt>
                <c:pt idx="16">
                  <c:v>B664</c:v>
                </c:pt>
                <c:pt idx="17">
                  <c:v>B664</c:v>
                </c:pt>
                <c:pt idx="18">
                  <c:v>B666</c:v>
                </c:pt>
                <c:pt idx="19">
                  <c:v>B666</c:v>
                </c:pt>
                <c:pt idx="20">
                  <c:v>B699</c:v>
                </c:pt>
                <c:pt idx="21">
                  <c:v>B699</c:v>
                </c:pt>
                <c:pt idx="22">
                  <c:v>B700</c:v>
                </c:pt>
                <c:pt idx="23">
                  <c:v>B700</c:v>
                </c:pt>
                <c:pt idx="24">
                  <c:v>B701</c:v>
                </c:pt>
                <c:pt idx="25">
                  <c:v>B701</c:v>
                </c:pt>
                <c:pt idx="26">
                  <c:v>B702</c:v>
                </c:pt>
                <c:pt idx="27">
                  <c:v>B702</c:v>
                </c:pt>
                <c:pt idx="28">
                  <c:v>B703</c:v>
                </c:pt>
                <c:pt idx="29">
                  <c:v>B703</c:v>
                </c:pt>
                <c:pt idx="30">
                  <c:v>B4292</c:v>
                </c:pt>
                <c:pt idx="31">
                  <c:v>B4292</c:v>
                </c:pt>
                <c:pt idx="32">
                  <c:v>B4293</c:v>
                </c:pt>
                <c:pt idx="33">
                  <c:v>B4293</c:v>
                </c:pt>
                <c:pt idx="34">
                  <c:v>B476</c:v>
                </c:pt>
                <c:pt idx="35">
                  <c:v>B476</c:v>
                </c:pt>
                <c:pt idx="36">
                  <c:v>B477</c:v>
                </c:pt>
                <c:pt idx="37">
                  <c:v>B477</c:v>
                </c:pt>
                <c:pt idx="38">
                  <c:v>B528</c:v>
                </c:pt>
                <c:pt idx="39">
                  <c:v>B528</c:v>
                </c:pt>
                <c:pt idx="40">
                  <c:v>B613</c:v>
                </c:pt>
                <c:pt idx="41">
                  <c:v>B613</c:v>
                </c:pt>
                <c:pt idx="42">
                  <c:v>B614</c:v>
                </c:pt>
                <c:pt idx="43">
                  <c:v>B614</c:v>
                </c:pt>
                <c:pt idx="44">
                  <c:v>B628</c:v>
                </c:pt>
                <c:pt idx="45">
                  <c:v>B628</c:v>
                </c:pt>
                <c:pt idx="46">
                  <c:v>B463</c:v>
                </c:pt>
                <c:pt idx="47">
                  <c:v>B463</c:v>
                </c:pt>
                <c:pt idx="48">
                  <c:v>B514</c:v>
                </c:pt>
                <c:pt idx="49">
                  <c:v>B514</c:v>
                </c:pt>
                <c:pt idx="50">
                  <c:v>B606</c:v>
                </c:pt>
                <c:pt idx="51">
                  <c:v>B606</c:v>
                </c:pt>
                <c:pt idx="52">
                  <c:v>B657</c:v>
                </c:pt>
                <c:pt idx="53">
                  <c:v>B657</c:v>
                </c:pt>
                <c:pt idx="54">
                  <c:v>B503</c:v>
                </c:pt>
                <c:pt idx="55">
                  <c:v>B503</c:v>
                </c:pt>
              </c:strCache>
            </c:strRef>
          </c:cat>
          <c:val>
            <c:numRef>
              <c:f>Sheet1!$B$9:$BE$9</c:f>
              <c:numCache>
                <c:formatCode>General</c:formatCode>
                <c:ptCount val="56"/>
                <c:pt idx="0">
                  <c:v>298.21800000000002</c:v>
                </c:pt>
                <c:pt idx="1">
                  <c:v>1607.22</c:v>
                </c:pt>
                <c:pt idx="2">
                  <c:v>35.792000000000002</c:v>
                </c:pt>
                <c:pt idx="3">
                  <c:v>567.01700000000005</c:v>
                </c:pt>
                <c:pt idx="4">
                  <c:v>24.803000000000001</c:v>
                </c:pt>
                <c:pt idx="5">
                  <c:v>253.21600000000001</c:v>
                </c:pt>
                <c:pt idx="6">
                  <c:v>23.902000000000001</c:v>
                </c:pt>
                <c:pt idx="7">
                  <c:v>1174.71</c:v>
                </c:pt>
                <c:pt idx="8">
                  <c:v>36.140999999999998</c:v>
                </c:pt>
                <c:pt idx="9">
                  <c:v>976.40499999999997</c:v>
                </c:pt>
                <c:pt idx="10">
                  <c:v>180.691</c:v>
                </c:pt>
                <c:pt idx="11">
                  <c:v>813.02200000000005</c:v>
                </c:pt>
                <c:pt idx="12">
                  <c:v>8.8330000000000002</c:v>
                </c:pt>
                <c:pt idx="13">
                  <c:v>430.08100000000002</c:v>
                </c:pt>
                <c:pt idx="14">
                  <c:v>12.135999999999999</c:v>
                </c:pt>
                <c:pt idx="15">
                  <c:v>512.45399999999995</c:v>
                </c:pt>
                <c:pt idx="16">
                  <c:v>31.702999999999999</c:v>
                </c:pt>
                <c:pt idx="17">
                  <c:v>419.67</c:v>
                </c:pt>
                <c:pt idx="18">
                  <c:v>129.74299999999999</c:v>
                </c:pt>
                <c:pt idx="19">
                  <c:v>557.04200000000003</c:v>
                </c:pt>
                <c:pt idx="20">
                  <c:v>33.844999999999999</c:v>
                </c:pt>
                <c:pt idx="21">
                  <c:v>680.64599999999996</c:v>
                </c:pt>
                <c:pt idx="22">
                  <c:v>21.268000000000001</c:v>
                </c:pt>
                <c:pt idx="23">
                  <c:v>306.358</c:v>
                </c:pt>
                <c:pt idx="24">
                  <c:v>22.901</c:v>
                </c:pt>
                <c:pt idx="25">
                  <c:v>288.04899999999998</c:v>
                </c:pt>
                <c:pt idx="26">
                  <c:v>17.812000000000001</c:v>
                </c:pt>
                <c:pt idx="27">
                  <c:v>941.178</c:v>
                </c:pt>
                <c:pt idx="28">
                  <c:v>10.222</c:v>
                </c:pt>
                <c:pt idx="29">
                  <c:v>389.625</c:v>
                </c:pt>
                <c:pt idx="30">
                  <c:v>49.517000000000003</c:v>
                </c:pt>
                <c:pt idx="31">
                  <c:v>2256.39</c:v>
                </c:pt>
                <c:pt idx="32">
                  <c:v>14.036</c:v>
                </c:pt>
                <c:pt idx="33">
                  <c:v>192.875</c:v>
                </c:pt>
                <c:pt idx="34">
                  <c:v>101.65900000000001</c:v>
                </c:pt>
                <c:pt idx="35">
                  <c:v>908.86300000000006</c:v>
                </c:pt>
                <c:pt idx="36">
                  <c:v>231.619</c:v>
                </c:pt>
                <c:pt idx="37">
                  <c:v>510.47</c:v>
                </c:pt>
                <c:pt idx="38">
                  <c:v>98.308000000000007</c:v>
                </c:pt>
                <c:pt idx="39">
                  <c:v>355.08699999999999</c:v>
                </c:pt>
                <c:pt idx="40">
                  <c:v>170.54</c:v>
                </c:pt>
                <c:pt idx="41">
                  <c:v>1164.17</c:v>
                </c:pt>
                <c:pt idx="42">
                  <c:v>228.53100000000001</c:v>
                </c:pt>
                <c:pt idx="43">
                  <c:v>2296.81</c:v>
                </c:pt>
                <c:pt idx="44">
                  <c:v>37.908000000000001</c:v>
                </c:pt>
                <c:pt idx="45">
                  <c:v>1019.33</c:v>
                </c:pt>
                <c:pt idx="46">
                  <c:v>160.36199999999999</c:v>
                </c:pt>
                <c:pt idx="47">
                  <c:v>248.285</c:v>
                </c:pt>
                <c:pt idx="48">
                  <c:v>363.23399999999998</c:v>
                </c:pt>
                <c:pt idx="49">
                  <c:v>1554.75</c:v>
                </c:pt>
                <c:pt idx="50">
                  <c:v>328.23599999999999</c:v>
                </c:pt>
                <c:pt idx="51">
                  <c:v>1562.28</c:v>
                </c:pt>
                <c:pt idx="52">
                  <c:v>90.834999999999994</c:v>
                </c:pt>
                <c:pt idx="53">
                  <c:v>226.54499999999999</c:v>
                </c:pt>
                <c:pt idx="54">
                  <c:v>151.87</c:v>
                </c:pt>
                <c:pt idx="55">
                  <c:v>702.331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8-EB45-433C-83A8-CBA27359976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"/>
        <c:overlap val="-27"/>
        <c:axId val="843511712"/>
        <c:axId val="843512040"/>
      </c:barChart>
      <c:catAx>
        <c:axId val="8435117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43512040"/>
        <c:crosses val="autoZero"/>
        <c:auto val="1"/>
        <c:lblAlgn val="ctr"/>
        <c:lblOffset val="100"/>
        <c:noMultiLvlLbl val="0"/>
      </c:catAx>
      <c:valAx>
        <c:axId val="8435120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43511712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IL6</a:t>
            </a:r>
          </a:p>
        </c:rich>
      </c:tx>
      <c:layout>
        <c:manualLayout>
          <c:xMode val="edge"/>
          <c:yMode val="edge"/>
          <c:x val="0.45840297388986712"/>
          <c:y val="4.499993117528582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6.6627536536835841E-2"/>
          <c:y val="0.12471108201549559"/>
          <c:w val="0.92587129140503011"/>
          <c:h val="0.757408278250087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88A1-437A-82C5-A7D86F870668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88A1-437A-82C5-A7D86F870668}"/>
              </c:ext>
            </c:extLst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88A1-437A-82C5-A7D86F870668}"/>
              </c:ext>
            </c:extLst>
          </c:dPt>
          <c:dPt>
            <c:idx val="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88A1-437A-82C5-A7D86F870668}"/>
              </c:ext>
            </c:extLst>
          </c:dPt>
          <c:dPt>
            <c:idx val="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88A1-437A-82C5-A7D86F870668}"/>
              </c:ext>
            </c:extLst>
          </c:dPt>
          <c:dPt>
            <c:idx val="1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88A1-437A-82C5-A7D86F870668}"/>
              </c:ext>
            </c:extLst>
          </c:dPt>
          <c:dPt>
            <c:idx val="1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88A1-437A-82C5-A7D86F870668}"/>
              </c:ext>
            </c:extLst>
          </c:dPt>
          <c:dPt>
            <c:idx val="1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88A1-437A-82C5-A7D86F870668}"/>
              </c:ext>
            </c:extLst>
          </c:dPt>
          <c:dPt>
            <c:idx val="1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88A1-437A-82C5-A7D86F870668}"/>
              </c:ext>
            </c:extLst>
          </c:dPt>
          <c:dPt>
            <c:idx val="1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3-88A1-437A-82C5-A7D86F870668}"/>
              </c:ext>
            </c:extLst>
          </c:dPt>
          <c:dPt>
            <c:idx val="2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5-88A1-437A-82C5-A7D86F870668}"/>
              </c:ext>
            </c:extLst>
          </c:dPt>
          <c:dPt>
            <c:idx val="2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7-88A1-437A-82C5-A7D86F870668}"/>
              </c:ext>
            </c:extLst>
          </c:dPt>
          <c:dPt>
            <c:idx val="2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9-88A1-437A-82C5-A7D86F870668}"/>
              </c:ext>
            </c:extLst>
          </c:dPt>
          <c:dPt>
            <c:idx val="2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B-88A1-437A-82C5-A7D86F870668}"/>
              </c:ext>
            </c:extLst>
          </c:dPt>
          <c:dPt>
            <c:idx val="2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D-88A1-437A-82C5-A7D86F870668}"/>
              </c:ext>
            </c:extLst>
          </c:dPt>
          <c:dPt>
            <c:idx val="3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F-88A1-437A-82C5-A7D86F870668}"/>
              </c:ext>
            </c:extLst>
          </c:dPt>
          <c:dPt>
            <c:idx val="3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1-88A1-437A-82C5-A7D86F870668}"/>
              </c:ext>
            </c:extLst>
          </c:dPt>
          <c:dPt>
            <c:idx val="3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3-88A1-437A-82C5-A7D86F870668}"/>
              </c:ext>
            </c:extLst>
          </c:dPt>
          <c:dPt>
            <c:idx val="3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5-88A1-437A-82C5-A7D86F870668}"/>
              </c:ext>
            </c:extLst>
          </c:dPt>
          <c:dPt>
            <c:idx val="3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7-88A1-437A-82C5-A7D86F870668}"/>
              </c:ext>
            </c:extLst>
          </c:dPt>
          <c:dPt>
            <c:idx val="4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9-88A1-437A-82C5-A7D86F870668}"/>
              </c:ext>
            </c:extLst>
          </c:dPt>
          <c:dPt>
            <c:idx val="4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B-88A1-437A-82C5-A7D86F870668}"/>
              </c:ext>
            </c:extLst>
          </c:dPt>
          <c:dPt>
            <c:idx val="4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D-88A1-437A-82C5-A7D86F870668}"/>
              </c:ext>
            </c:extLst>
          </c:dPt>
          <c:dPt>
            <c:idx val="4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F-88A1-437A-82C5-A7D86F870668}"/>
              </c:ext>
            </c:extLst>
          </c:dPt>
          <c:dPt>
            <c:idx val="4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1-88A1-437A-82C5-A7D86F870668}"/>
              </c:ext>
            </c:extLst>
          </c:dPt>
          <c:dPt>
            <c:idx val="5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3-88A1-437A-82C5-A7D86F870668}"/>
              </c:ext>
            </c:extLst>
          </c:dPt>
          <c:dPt>
            <c:idx val="5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5-88A1-437A-82C5-A7D86F870668}"/>
              </c:ext>
            </c:extLst>
          </c:dPt>
          <c:dPt>
            <c:idx val="5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7-88A1-437A-82C5-A7D86F870668}"/>
              </c:ext>
            </c:extLst>
          </c:dPt>
          <c:cat>
            <c:strRef>
              <c:f>Sheet1!$B$1:$BE$1</c:f>
              <c:strCache>
                <c:ptCount val="56"/>
                <c:pt idx="0">
                  <c:v>B510</c:v>
                </c:pt>
                <c:pt idx="1">
                  <c:v>B510</c:v>
                </c:pt>
                <c:pt idx="2">
                  <c:v>B459</c:v>
                </c:pt>
                <c:pt idx="3">
                  <c:v>B459</c:v>
                </c:pt>
                <c:pt idx="4">
                  <c:v>B512</c:v>
                </c:pt>
                <c:pt idx="5">
                  <c:v>B512</c:v>
                </c:pt>
                <c:pt idx="6">
                  <c:v>B513</c:v>
                </c:pt>
                <c:pt idx="7">
                  <c:v>B513</c:v>
                </c:pt>
                <c:pt idx="8">
                  <c:v>B540</c:v>
                </c:pt>
                <c:pt idx="9">
                  <c:v>B540</c:v>
                </c:pt>
                <c:pt idx="10">
                  <c:v>B541</c:v>
                </c:pt>
                <c:pt idx="11">
                  <c:v>B541</c:v>
                </c:pt>
                <c:pt idx="12">
                  <c:v>B542</c:v>
                </c:pt>
                <c:pt idx="13">
                  <c:v>B542</c:v>
                </c:pt>
                <c:pt idx="14">
                  <c:v>B643</c:v>
                </c:pt>
                <c:pt idx="15">
                  <c:v>B643</c:v>
                </c:pt>
                <c:pt idx="16">
                  <c:v>B664</c:v>
                </c:pt>
                <c:pt idx="17">
                  <c:v>B664</c:v>
                </c:pt>
                <c:pt idx="18">
                  <c:v>B666</c:v>
                </c:pt>
                <c:pt idx="19">
                  <c:v>B666</c:v>
                </c:pt>
                <c:pt idx="20">
                  <c:v>B699</c:v>
                </c:pt>
                <c:pt idx="21">
                  <c:v>B699</c:v>
                </c:pt>
                <c:pt idx="22">
                  <c:v>B700</c:v>
                </c:pt>
                <c:pt idx="23">
                  <c:v>B700</c:v>
                </c:pt>
                <c:pt idx="24">
                  <c:v>B701</c:v>
                </c:pt>
                <c:pt idx="25">
                  <c:v>B701</c:v>
                </c:pt>
                <c:pt idx="26">
                  <c:v>B702</c:v>
                </c:pt>
                <c:pt idx="27">
                  <c:v>B702</c:v>
                </c:pt>
                <c:pt idx="28">
                  <c:v>B703</c:v>
                </c:pt>
                <c:pt idx="29">
                  <c:v>B703</c:v>
                </c:pt>
                <c:pt idx="30">
                  <c:v>B4292</c:v>
                </c:pt>
                <c:pt idx="31">
                  <c:v>B4292</c:v>
                </c:pt>
                <c:pt idx="32">
                  <c:v>B4293</c:v>
                </c:pt>
                <c:pt idx="33">
                  <c:v>B4293</c:v>
                </c:pt>
                <c:pt idx="34">
                  <c:v>B476</c:v>
                </c:pt>
                <c:pt idx="35">
                  <c:v>B476</c:v>
                </c:pt>
                <c:pt idx="36">
                  <c:v>B477</c:v>
                </c:pt>
                <c:pt idx="37">
                  <c:v>B477</c:v>
                </c:pt>
                <c:pt idx="38">
                  <c:v>B528</c:v>
                </c:pt>
                <c:pt idx="39">
                  <c:v>B528</c:v>
                </c:pt>
                <c:pt idx="40">
                  <c:v>B613</c:v>
                </c:pt>
                <c:pt idx="41">
                  <c:v>B613</c:v>
                </c:pt>
                <c:pt idx="42">
                  <c:v>B614</c:v>
                </c:pt>
                <c:pt idx="43">
                  <c:v>B614</c:v>
                </c:pt>
                <c:pt idx="44">
                  <c:v>B628</c:v>
                </c:pt>
                <c:pt idx="45">
                  <c:v>B628</c:v>
                </c:pt>
                <c:pt idx="46">
                  <c:v>B463</c:v>
                </c:pt>
                <c:pt idx="47">
                  <c:v>B463</c:v>
                </c:pt>
                <c:pt idx="48">
                  <c:v>B514</c:v>
                </c:pt>
                <c:pt idx="49">
                  <c:v>B514</c:v>
                </c:pt>
                <c:pt idx="50">
                  <c:v>B606</c:v>
                </c:pt>
                <c:pt idx="51">
                  <c:v>B606</c:v>
                </c:pt>
                <c:pt idx="52">
                  <c:v>B657</c:v>
                </c:pt>
                <c:pt idx="53">
                  <c:v>B657</c:v>
                </c:pt>
                <c:pt idx="54">
                  <c:v>B503</c:v>
                </c:pt>
                <c:pt idx="55">
                  <c:v>B503</c:v>
                </c:pt>
              </c:strCache>
            </c:strRef>
          </c:cat>
          <c:val>
            <c:numRef>
              <c:f>Sheet1!$B$3:$BE$3</c:f>
              <c:numCache>
                <c:formatCode>General</c:formatCode>
                <c:ptCount val="56"/>
                <c:pt idx="0">
                  <c:v>0.86399999999999999</c:v>
                </c:pt>
                <c:pt idx="1">
                  <c:v>90.504999999999995</c:v>
                </c:pt>
                <c:pt idx="2">
                  <c:v>1.0569999999999999</c:v>
                </c:pt>
                <c:pt idx="3">
                  <c:v>23.055</c:v>
                </c:pt>
                <c:pt idx="4">
                  <c:v>0.13900000000000001</c:v>
                </c:pt>
                <c:pt idx="5">
                  <c:v>10.683999999999999</c:v>
                </c:pt>
                <c:pt idx="6">
                  <c:v>0.51300000000000001</c:v>
                </c:pt>
                <c:pt idx="7">
                  <c:v>96.524000000000001</c:v>
                </c:pt>
                <c:pt idx="8">
                  <c:v>2.3650000000000002</c:v>
                </c:pt>
                <c:pt idx="9">
                  <c:v>25.143000000000001</c:v>
                </c:pt>
                <c:pt idx="10">
                  <c:v>8.9939999999999998</c:v>
                </c:pt>
                <c:pt idx="11">
                  <c:v>11.824999999999999</c:v>
                </c:pt>
                <c:pt idx="12">
                  <c:v>0</c:v>
                </c:pt>
                <c:pt idx="13">
                  <c:v>22.984000000000002</c:v>
                </c:pt>
                <c:pt idx="14">
                  <c:v>0.22500000000000001</c:v>
                </c:pt>
                <c:pt idx="15">
                  <c:v>15.387</c:v>
                </c:pt>
                <c:pt idx="16">
                  <c:v>0.14199999999999999</c:v>
                </c:pt>
                <c:pt idx="17">
                  <c:v>7.3520000000000003</c:v>
                </c:pt>
                <c:pt idx="18">
                  <c:v>5.2169999999999996</c:v>
                </c:pt>
                <c:pt idx="19">
                  <c:v>24.326000000000001</c:v>
                </c:pt>
                <c:pt idx="20">
                  <c:v>6.7000000000000004E-2</c:v>
                </c:pt>
                <c:pt idx="21">
                  <c:v>26.007999999999999</c:v>
                </c:pt>
                <c:pt idx="22">
                  <c:v>0.432</c:v>
                </c:pt>
                <c:pt idx="23">
                  <c:v>6.95</c:v>
                </c:pt>
                <c:pt idx="24">
                  <c:v>0.60899999999999999</c:v>
                </c:pt>
                <c:pt idx="25">
                  <c:v>15.989000000000001</c:v>
                </c:pt>
                <c:pt idx="26">
                  <c:v>0.98299999999999998</c:v>
                </c:pt>
                <c:pt idx="27">
                  <c:v>66.138999999999996</c:v>
                </c:pt>
                <c:pt idx="28">
                  <c:v>1.92</c:v>
                </c:pt>
                <c:pt idx="29">
                  <c:v>28.885999999999999</c:v>
                </c:pt>
                <c:pt idx="30">
                  <c:v>2.4910000000000001</c:v>
                </c:pt>
                <c:pt idx="31">
                  <c:v>79.031000000000006</c:v>
                </c:pt>
                <c:pt idx="32">
                  <c:v>4.8000000000000001E-2</c:v>
                </c:pt>
                <c:pt idx="33">
                  <c:v>2.3050000000000002</c:v>
                </c:pt>
                <c:pt idx="34">
                  <c:v>2.2650000000000001</c:v>
                </c:pt>
                <c:pt idx="35">
                  <c:v>67.825000000000003</c:v>
                </c:pt>
                <c:pt idx="36">
                  <c:v>9.7680000000000007</c:v>
                </c:pt>
                <c:pt idx="37">
                  <c:v>23.943000000000001</c:v>
                </c:pt>
                <c:pt idx="38">
                  <c:v>0.25900000000000001</c:v>
                </c:pt>
                <c:pt idx="39">
                  <c:v>1.504</c:v>
                </c:pt>
                <c:pt idx="40">
                  <c:v>3.5510000000000002</c:v>
                </c:pt>
                <c:pt idx="41">
                  <c:v>50.892000000000003</c:v>
                </c:pt>
                <c:pt idx="42">
                  <c:v>3.2589999999999999</c:v>
                </c:pt>
                <c:pt idx="43">
                  <c:v>49.874000000000002</c:v>
                </c:pt>
                <c:pt idx="44">
                  <c:v>1.649</c:v>
                </c:pt>
                <c:pt idx="45">
                  <c:v>38.823999999999998</c:v>
                </c:pt>
                <c:pt idx="46">
                  <c:v>2.8130000000000002</c:v>
                </c:pt>
                <c:pt idx="47">
                  <c:v>7.0519999999999996</c:v>
                </c:pt>
                <c:pt idx="48">
                  <c:v>4.0209999999999999</c:v>
                </c:pt>
                <c:pt idx="49">
                  <c:v>56.966000000000001</c:v>
                </c:pt>
                <c:pt idx="50">
                  <c:v>2.5539999999999998</c:v>
                </c:pt>
                <c:pt idx="51">
                  <c:v>27.64</c:v>
                </c:pt>
                <c:pt idx="52">
                  <c:v>0.20599999999999999</c:v>
                </c:pt>
                <c:pt idx="53">
                  <c:v>23.571999999999999</c:v>
                </c:pt>
                <c:pt idx="54">
                  <c:v>0.121</c:v>
                </c:pt>
                <c:pt idx="55">
                  <c:v>2.0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8-88A1-437A-82C5-A7D86F87066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"/>
        <c:overlap val="-27"/>
        <c:axId val="843511712"/>
        <c:axId val="843512040"/>
      </c:barChart>
      <c:catAx>
        <c:axId val="8435117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43512040"/>
        <c:crosses val="autoZero"/>
        <c:auto val="1"/>
        <c:lblAlgn val="ctr"/>
        <c:lblOffset val="100"/>
        <c:noMultiLvlLbl val="0"/>
      </c:catAx>
      <c:valAx>
        <c:axId val="8435120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43511712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BLB2</a:t>
            </a:r>
          </a:p>
        </c:rich>
      </c:tx>
      <c:layout>
        <c:manualLayout>
          <c:xMode val="edge"/>
          <c:yMode val="edge"/>
          <c:x val="0.44152533675906547"/>
          <c:y val="5.092585571866883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E615-43F2-A339-80B345332422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E615-43F2-A339-80B345332422}"/>
              </c:ext>
            </c:extLst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E615-43F2-A339-80B345332422}"/>
              </c:ext>
            </c:extLst>
          </c:dPt>
          <c:dPt>
            <c:idx val="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E615-43F2-A339-80B345332422}"/>
              </c:ext>
            </c:extLst>
          </c:dPt>
          <c:dPt>
            <c:idx val="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E615-43F2-A339-80B345332422}"/>
              </c:ext>
            </c:extLst>
          </c:dPt>
          <c:dPt>
            <c:idx val="1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E615-43F2-A339-80B345332422}"/>
              </c:ext>
            </c:extLst>
          </c:dPt>
          <c:dPt>
            <c:idx val="1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E615-43F2-A339-80B345332422}"/>
              </c:ext>
            </c:extLst>
          </c:dPt>
          <c:dPt>
            <c:idx val="1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E615-43F2-A339-80B345332422}"/>
              </c:ext>
            </c:extLst>
          </c:dPt>
          <c:dPt>
            <c:idx val="1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E615-43F2-A339-80B345332422}"/>
              </c:ext>
            </c:extLst>
          </c:dPt>
          <c:dPt>
            <c:idx val="1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3-E615-43F2-A339-80B345332422}"/>
              </c:ext>
            </c:extLst>
          </c:dPt>
          <c:dPt>
            <c:idx val="2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5-E615-43F2-A339-80B345332422}"/>
              </c:ext>
            </c:extLst>
          </c:dPt>
          <c:dPt>
            <c:idx val="2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7-E615-43F2-A339-80B345332422}"/>
              </c:ext>
            </c:extLst>
          </c:dPt>
          <c:dPt>
            <c:idx val="2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9-E615-43F2-A339-80B345332422}"/>
              </c:ext>
            </c:extLst>
          </c:dPt>
          <c:dPt>
            <c:idx val="2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B-E615-43F2-A339-80B345332422}"/>
              </c:ext>
            </c:extLst>
          </c:dPt>
          <c:dPt>
            <c:idx val="2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D-E615-43F2-A339-80B345332422}"/>
              </c:ext>
            </c:extLst>
          </c:dPt>
          <c:dPt>
            <c:idx val="3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F-E615-43F2-A339-80B345332422}"/>
              </c:ext>
            </c:extLst>
          </c:dPt>
          <c:dPt>
            <c:idx val="3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1-E615-43F2-A339-80B345332422}"/>
              </c:ext>
            </c:extLst>
          </c:dPt>
          <c:dPt>
            <c:idx val="3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3-E615-43F2-A339-80B345332422}"/>
              </c:ext>
            </c:extLst>
          </c:dPt>
          <c:dPt>
            <c:idx val="3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5-E615-43F2-A339-80B345332422}"/>
              </c:ext>
            </c:extLst>
          </c:dPt>
          <c:dPt>
            <c:idx val="3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7-E615-43F2-A339-80B345332422}"/>
              </c:ext>
            </c:extLst>
          </c:dPt>
          <c:dPt>
            <c:idx val="4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9-E615-43F2-A339-80B345332422}"/>
              </c:ext>
            </c:extLst>
          </c:dPt>
          <c:dPt>
            <c:idx val="4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B-E615-43F2-A339-80B345332422}"/>
              </c:ext>
            </c:extLst>
          </c:dPt>
          <c:dPt>
            <c:idx val="4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D-E615-43F2-A339-80B345332422}"/>
              </c:ext>
            </c:extLst>
          </c:dPt>
          <c:dPt>
            <c:idx val="4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F-E615-43F2-A339-80B345332422}"/>
              </c:ext>
            </c:extLst>
          </c:dPt>
          <c:dPt>
            <c:idx val="4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1-E615-43F2-A339-80B345332422}"/>
              </c:ext>
            </c:extLst>
          </c:dPt>
          <c:dPt>
            <c:idx val="5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3-E615-43F2-A339-80B345332422}"/>
              </c:ext>
            </c:extLst>
          </c:dPt>
          <c:dPt>
            <c:idx val="5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5-E615-43F2-A339-80B345332422}"/>
              </c:ext>
            </c:extLst>
          </c:dPt>
          <c:dPt>
            <c:idx val="5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7-E615-43F2-A339-80B345332422}"/>
              </c:ext>
            </c:extLst>
          </c:dPt>
          <c:cat>
            <c:strRef>
              <c:f>Sheet1!$B$1:$BE$1</c:f>
              <c:strCache>
                <c:ptCount val="56"/>
                <c:pt idx="0">
                  <c:v>B510</c:v>
                </c:pt>
                <c:pt idx="1">
                  <c:v>B510</c:v>
                </c:pt>
                <c:pt idx="2">
                  <c:v>B459</c:v>
                </c:pt>
                <c:pt idx="3">
                  <c:v>B459</c:v>
                </c:pt>
                <c:pt idx="4">
                  <c:v>B512</c:v>
                </c:pt>
                <c:pt idx="5">
                  <c:v>B512</c:v>
                </c:pt>
                <c:pt idx="6">
                  <c:v>B513</c:v>
                </c:pt>
                <c:pt idx="7">
                  <c:v>B513</c:v>
                </c:pt>
                <c:pt idx="8">
                  <c:v>B540</c:v>
                </c:pt>
                <c:pt idx="9">
                  <c:v>B540</c:v>
                </c:pt>
                <c:pt idx="10">
                  <c:v>B541</c:v>
                </c:pt>
                <c:pt idx="11">
                  <c:v>B541</c:v>
                </c:pt>
                <c:pt idx="12">
                  <c:v>B542</c:v>
                </c:pt>
                <c:pt idx="13">
                  <c:v>B542</c:v>
                </c:pt>
                <c:pt idx="14">
                  <c:v>B643</c:v>
                </c:pt>
                <c:pt idx="15">
                  <c:v>B643</c:v>
                </c:pt>
                <c:pt idx="16">
                  <c:v>B664</c:v>
                </c:pt>
                <c:pt idx="17">
                  <c:v>B664</c:v>
                </c:pt>
                <c:pt idx="18">
                  <c:v>B666</c:v>
                </c:pt>
                <c:pt idx="19">
                  <c:v>B666</c:v>
                </c:pt>
                <c:pt idx="20">
                  <c:v>B699</c:v>
                </c:pt>
                <c:pt idx="21">
                  <c:v>B699</c:v>
                </c:pt>
                <c:pt idx="22">
                  <c:v>B700</c:v>
                </c:pt>
                <c:pt idx="23">
                  <c:v>B700</c:v>
                </c:pt>
                <c:pt idx="24">
                  <c:v>B701</c:v>
                </c:pt>
                <c:pt idx="25">
                  <c:v>B701</c:v>
                </c:pt>
                <c:pt idx="26">
                  <c:v>B702</c:v>
                </c:pt>
                <c:pt idx="27">
                  <c:v>B702</c:v>
                </c:pt>
                <c:pt idx="28">
                  <c:v>B703</c:v>
                </c:pt>
                <c:pt idx="29">
                  <c:v>B703</c:v>
                </c:pt>
                <c:pt idx="30">
                  <c:v>B4292</c:v>
                </c:pt>
                <c:pt idx="31">
                  <c:v>B4292</c:v>
                </c:pt>
                <c:pt idx="32">
                  <c:v>B4293</c:v>
                </c:pt>
                <c:pt idx="33">
                  <c:v>B4293</c:v>
                </c:pt>
                <c:pt idx="34">
                  <c:v>B476</c:v>
                </c:pt>
                <c:pt idx="35">
                  <c:v>B476</c:v>
                </c:pt>
                <c:pt idx="36">
                  <c:v>B477</c:v>
                </c:pt>
                <c:pt idx="37">
                  <c:v>B477</c:v>
                </c:pt>
                <c:pt idx="38">
                  <c:v>B528</c:v>
                </c:pt>
                <c:pt idx="39">
                  <c:v>B528</c:v>
                </c:pt>
                <c:pt idx="40">
                  <c:v>B613</c:v>
                </c:pt>
                <c:pt idx="41">
                  <c:v>B613</c:v>
                </c:pt>
                <c:pt idx="42">
                  <c:v>B614</c:v>
                </c:pt>
                <c:pt idx="43">
                  <c:v>B614</c:v>
                </c:pt>
                <c:pt idx="44">
                  <c:v>B628</c:v>
                </c:pt>
                <c:pt idx="45">
                  <c:v>B628</c:v>
                </c:pt>
                <c:pt idx="46">
                  <c:v>B463</c:v>
                </c:pt>
                <c:pt idx="47">
                  <c:v>B463</c:v>
                </c:pt>
                <c:pt idx="48">
                  <c:v>B514</c:v>
                </c:pt>
                <c:pt idx="49">
                  <c:v>B514</c:v>
                </c:pt>
                <c:pt idx="50">
                  <c:v>B606</c:v>
                </c:pt>
                <c:pt idx="51">
                  <c:v>B606</c:v>
                </c:pt>
                <c:pt idx="52">
                  <c:v>B657</c:v>
                </c:pt>
                <c:pt idx="53">
                  <c:v>B657</c:v>
                </c:pt>
                <c:pt idx="54">
                  <c:v>B503</c:v>
                </c:pt>
                <c:pt idx="55">
                  <c:v>B503</c:v>
                </c:pt>
              </c:strCache>
            </c:strRef>
          </c:cat>
          <c:val>
            <c:numRef>
              <c:f>Sheet1!$B$6:$BE$6</c:f>
              <c:numCache>
                <c:formatCode>General</c:formatCode>
                <c:ptCount val="56"/>
                <c:pt idx="0">
                  <c:v>4.5739999999999998</c:v>
                </c:pt>
                <c:pt idx="1">
                  <c:v>5.2279999999999998</c:v>
                </c:pt>
                <c:pt idx="2">
                  <c:v>17.344000000000001</c:v>
                </c:pt>
                <c:pt idx="3">
                  <c:v>31.129000000000001</c:v>
                </c:pt>
                <c:pt idx="4">
                  <c:v>44.436999999999998</c:v>
                </c:pt>
                <c:pt idx="5">
                  <c:v>37.103999999999999</c:v>
                </c:pt>
                <c:pt idx="6">
                  <c:v>9.5660000000000007</c:v>
                </c:pt>
                <c:pt idx="7">
                  <c:v>37.969000000000001</c:v>
                </c:pt>
                <c:pt idx="8">
                  <c:v>37.71</c:v>
                </c:pt>
                <c:pt idx="9">
                  <c:v>67.238</c:v>
                </c:pt>
                <c:pt idx="10">
                  <c:v>122.37</c:v>
                </c:pt>
                <c:pt idx="11">
                  <c:v>81.765000000000001</c:v>
                </c:pt>
                <c:pt idx="12">
                  <c:v>10.743</c:v>
                </c:pt>
                <c:pt idx="13">
                  <c:v>27.698</c:v>
                </c:pt>
                <c:pt idx="14">
                  <c:v>4.915</c:v>
                </c:pt>
                <c:pt idx="15">
                  <c:v>6.8650000000000002</c:v>
                </c:pt>
                <c:pt idx="16">
                  <c:v>55.613999999999997</c:v>
                </c:pt>
                <c:pt idx="17">
                  <c:v>93.344999999999999</c:v>
                </c:pt>
                <c:pt idx="18">
                  <c:v>6.0419999999999998</c:v>
                </c:pt>
                <c:pt idx="19">
                  <c:v>21.792000000000002</c:v>
                </c:pt>
                <c:pt idx="20">
                  <c:v>44.968000000000004</c:v>
                </c:pt>
                <c:pt idx="21">
                  <c:v>48.085000000000001</c:v>
                </c:pt>
                <c:pt idx="22">
                  <c:v>107.867</c:v>
                </c:pt>
                <c:pt idx="23">
                  <c:v>113.164</c:v>
                </c:pt>
                <c:pt idx="24">
                  <c:v>44.134999999999998</c:v>
                </c:pt>
                <c:pt idx="25">
                  <c:v>57.564999999999998</c:v>
                </c:pt>
                <c:pt idx="26">
                  <c:v>42.231000000000002</c:v>
                </c:pt>
                <c:pt idx="27">
                  <c:v>34.831000000000003</c:v>
                </c:pt>
                <c:pt idx="28">
                  <c:v>4.0149999999999997</c:v>
                </c:pt>
                <c:pt idx="29">
                  <c:v>51.41</c:v>
                </c:pt>
                <c:pt idx="30">
                  <c:v>67.051000000000002</c:v>
                </c:pt>
                <c:pt idx="31">
                  <c:v>36.472000000000001</c:v>
                </c:pt>
                <c:pt idx="32">
                  <c:v>14.134</c:v>
                </c:pt>
                <c:pt idx="33">
                  <c:v>27.632999999999999</c:v>
                </c:pt>
                <c:pt idx="34">
                  <c:v>4.9359999999999999</c:v>
                </c:pt>
                <c:pt idx="35">
                  <c:v>10.539</c:v>
                </c:pt>
                <c:pt idx="36">
                  <c:v>14.702</c:v>
                </c:pt>
                <c:pt idx="37">
                  <c:v>20.407</c:v>
                </c:pt>
                <c:pt idx="38">
                  <c:v>18.634</c:v>
                </c:pt>
                <c:pt idx="39">
                  <c:v>38.784999999999997</c:v>
                </c:pt>
                <c:pt idx="40">
                  <c:v>42.569000000000003</c:v>
                </c:pt>
                <c:pt idx="41">
                  <c:v>52.100999999999999</c:v>
                </c:pt>
                <c:pt idx="42">
                  <c:v>3.4550000000000001</c:v>
                </c:pt>
                <c:pt idx="43">
                  <c:v>6.3540000000000001</c:v>
                </c:pt>
                <c:pt idx="44">
                  <c:v>25.192</c:v>
                </c:pt>
                <c:pt idx="45">
                  <c:v>47.6</c:v>
                </c:pt>
                <c:pt idx="46">
                  <c:v>13.118</c:v>
                </c:pt>
                <c:pt idx="47">
                  <c:v>11.975</c:v>
                </c:pt>
                <c:pt idx="48">
                  <c:v>13.305999999999999</c:v>
                </c:pt>
                <c:pt idx="49">
                  <c:v>10.817</c:v>
                </c:pt>
                <c:pt idx="50">
                  <c:v>7.2789999999999999</c:v>
                </c:pt>
                <c:pt idx="51">
                  <c:v>6.843</c:v>
                </c:pt>
                <c:pt idx="52">
                  <c:v>14.596</c:v>
                </c:pt>
                <c:pt idx="53">
                  <c:v>12.704000000000001</c:v>
                </c:pt>
                <c:pt idx="54">
                  <c:v>2.7719999999999998</c:v>
                </c:pt>
                <c:pt idx="55">
                  <c:v>2.487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8-E615-43F2-A339-80B34533242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"/>
        <c:overlap val="-27"/>
        <c:axId val="843511712"/>
        <c:axId val="843512040"/>
      </c:barChart>
      <c:catAx>
        <c:axId val="8435117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43512040"/>
        <c:crosses val="autoZero"/>
        <c:auto val="1"/>
        <c:lblAlgn val="ctr"/>
        <c:lblOffset val="100"/>
        <c:noMultiLvlLbl val="0"/>
      </c:catAx>
      <c:valAx>
        <c:axId val="8435120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43511712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CD74</a:t>
            </a:r>
          </a:p>
        </c:rich>
      </c:tx>
      <c:layout>
        <c:manualLayout>
          <c:xMode val="edge"/>
          <c:yMode val="edge"/>
          <c:x val="0.43777475072999833"/>
          <c:y val="3.611104436021128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34A3-4556-867C-5676E9CF06F5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34A3-4556-867C-5676E9CF06F5}"/>
              </c:ext>
            </c:extLst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34A3-4556-867C-5676E9CF06F5}"/>
              </c:ext>
            </c:extLst>
          </c:dPt>
          <c:dPt>
            <c:idx val="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34A3-4556-867C-5676E9CF06F5}"/>
              </c:ext>
            </c:extLst>
          </c:dPt>
          <c:dPt>
            <c:idx val="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34A3-4556-867C-5676E9CF06F5}"/>
              </c:ext>
            </c:extLst>
          </c:dPt>
          <c:dPt>
            <c:idx val="1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34A3-4556-867C-5676E9CF06F5}"/>
              </c:ext>
            </c:extLst>
          </c:dPt>
          <c:dPt>
            <c:idx val="1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34A3-4556-867C-5676E9CF06F5}"/>
              </c:ext>
            </c:extLst>
          </c:dPt>
          <c:dPt>
            <c:idx val="1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34A3-4556-867C-5676E9CF06F5}"/>
              </c:ext>
            </c:extLst>
          </c:dPt>
          <c:dPt>
            <c:idx val="1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34A3-4556-867C-5676E9CF06F5}"/>
              </c:ext>
            </c:extLst>
          </c:dPt>
          <c:dPt>
            <c:idx val="1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3-34A3-4556-867C-5676E9CF06F5}"/>
              </c:ext>
            </c:extLst>
          </c:dPt>
          <c:dPt>
            <c:idx val="2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5-34A3-4556-867C-5676E9CF06F5}"/>
              </c:ext>
            </c:extLst>
          </c:dPt>
          <c:dPt>
            <c:idx val="2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7-34A3-4556-867C-5676E9CF06F5}"/>
              </c:ext>
            </c:extLst>
          </c:dPt>
          <c:dPt>
            <c:idx val="2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9-34A3-4556-867C-5676E9CF06F5}"/>
              </c:ext>
            </c:extLst>
          </c:dPt>
          <c:dPt>
            <c:idx val="2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B-34A3-4556-867C-5676E9CF06F5}"/>
              </c:ext>
            </c:extLst>
          </c:dPt>
          <c:dPt>
            <c:idx val="2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D-34A3-4556-867C-5676E9CF06F5}"/>
              </c:ext>
            </c:extLst>
          </c:dPt>
          <c:dPt>
            <c:idx val="3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F-34A3-4556-867C-5676E9CF06F5}"/>
              </c:ext>
            </c:extLst>
          </c:dPt>
          <c:dPt>
            <c:idx val="3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1-34A3-4556-867C-5676E9CF06F5}"/>
              </c:ext>
            </c:extLst>
          </c:dPt>
          <c:dPt>
            <c:idx val="3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3-34A3-4556-867C-5676E9CF06F5}"/>
              </c:ext>
            </c:extLst>
          </c:dPt>
          <c:dPt>
            <c:idx val="3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5-34A3-4556-867C-5676E9CF06F5}"/>
              </c:ext>
            </c:extLst>
          </c:dPt>
          <c:dPt>
            <c:idx val="3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7-34A3-4556-867C-5676E9CF06F5}"/>
              </c:ext>
            </c:extLst>
          </c:dPt>
          <c:dPt>
            <c:idx val="4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9-34A3-4556-867C-5676E9CF06F5}"/>
              </c:ext>
            </c:extLst>
          </c:dPt>
          <c:dPt>
            <c:idx val="4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B-34A3-4556-867C-5676E9CF06F5}"/>
              </c:ext>
            </c:extLst>
          </c:dPt>
          <c:dPt>
            <c:idx val="4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D-34A3-4556-867C-5676E9CF06F5}"/>
              </c:ext>
            </c:extLst>
          </c:dPt>
          <c:dPt>
            <c:idx val="4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F-34A3-4556-867C-5676E9CF06F5}"/>
              </c:ext>
            </c:extLst>
          </c:dPt>
          <c:dPt>
            <c:idx val="4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1-34A3-4556-867C-5676E9CF06F5}"/>
              </c:ext>
            </c:extLst>
          </c:dPt>
          <c:dPt>
            <c:idx val="5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3-34A3-4556-867C-5676E9CF06F5}"/>
              </c:ext>
            </c:extLst>
          </c:dPt>
          <c:dPt>
            <c:idx val="5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5-34A3-4556-867C-5676E9CF06F5}"/>
              </c:ext>
            </c:extLst>
          </c:dPt>
          <c:dPt>
            <c:idx val="5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7-34A3-4556-867C-5676E9CF06F5}"/>
              </c:ext>
            </c:extLst>
          </c:dPt>
          <c:cat>
            <c:strRef>
              <c:f>Sheet1!$B$1:$BE$1</c:f>
              <c:strCache>
                <c:ptCount val="56"/>
                <c:pt idx="0">
                  <c:v>B510</c:v>
                </c:pt>
                <c:pt idx="1">
                  <c:v>B510</c:v>
                </c:pt>
                <c:pt idx="2">
                  <c:v>B459</c:v>
                </c:pt>
                <c:pt idx="3">
                  <c:v>B459</c:v>
                </c:pt>
                <c:pt idx="4">
                  <c:v>B512</c:v>
                </c:pt>
                <c:pt idx="5">
                  <c:v>B512</c:v>
                </c:pt>
                <c:pt idx="6">
                  <c:v>B513</c:v>
                </c:pt>
                <c:pt idx="7">
                  <c:v>B513</c:v>
                </c:pt>
                <c:pt idx="8">
                  <c:v>B540</c:v>
                </c:pt>
                <c:pt idx="9">
                  <c:v>B540</c:v>
                </c:pt>
                <c:pt idx="10">
                  <c:v>B541</c:v>
                </c:pt>
                <c:pt idx="11">
                  <c:v>B541</c:v>
                </c:pt>
                <c:pt idx="12">
                  <c:v>B542</c:v>
                </c:pt>
                <c:pt idx="13">
                  <c:v>B542</c:v>
                </c:pt>
                <c:pt idx="14">
                  <c:v>B643</c:v>
                </c:pt>
                <c:pt idx="15">
                  <c:v>B643</c:v>
                </c:pt>
                <c:pt idx="16">
                  <c:v>B664</c:v>
                </c:pt>
                <c:pt idx="17">
                  <c:v>B664</c:v>
                </c:pt>
                <c:pt idx="18">
                  <c:v>B666</c:v>
                </c:pt>
                <c:pt idx="19">
                  <c:v>B666</c:v>
                </c:pt>
                <c:pt idx="20">
                  <c:v>B699</c:v>
                </c:pt>
                <c:pt idx="21">
                  <c:v>B699</c:v>
                </c:pt>
                <c:pt idx="22">
                  <c:v>B700</c:v>
                </c:pt>
                <c:pt idx="23">
                  <c:v>B700</c:v>
                </c:pt>
                <c:pt idx="24">
                  <c:v>B701</c:v>
                </c:pt>
                <c:pt idx="25">
                  <c:v>B701</c:v>
                </c:pt>
                <c:pt idx="26">
                  <c:v>B702</c:v>
                </c:pt>
                <c:pt idx="27">
                  <c:v>B702</c:v>
                </c:pt>
                <c:pt idx="28">
                  <c:v>B703</c:v>
                </c:pt>
                <c:pt idx="29">
                  <c:v>B703</c:v>
                </c:pt>
                <c:pt idx="30">
                  <c:v>B4292</c:v>
                </c:pt>
                <c:pt idx="31">
                  <c:v>B4292</c:v>
                </c:pt>
                <c:pt idx="32">
                  <c:v>B4293</c:v>
                </c:pt>
                <c:pt idx="33">
                  <c:v>B4293</c:v>
                </c:pt>
                <c:pt idx="34">
                  <c:v>B476</c:v>
                </c:pt>
                <c:pt idx="35">
                  <c:v>B476</c:v>
                </c:pt>
                <c:pt idx="36">
                  <c:v>B477</c:v>
                </c:pt>
                <c:pt idx="37">
                  <c:v>B477</c:v>
                </c:pt>
                <c:pt idx="38">
                  <c:v>B528</c:v>
                </c:pt>
                <c:pt idx="39">
                  <c:v>B528</c:v>
                </c:pt>
                <c:pt idx="40">
                  <c:v>B613</c:v>
                </c:pt>
                <c:pt idx="41">
                  <c:v>B613</c:v>
                </c:pt>
                <c:pt idx="42">
                  <c:v>B614</c:v>
                </c:pt>
                <c:pt idx="43">
                  <c:v>B614</c:v>
                </c:pt>
                <c:pt idx="44">
                  <c:v>B628</c:v>
                </c:pt>
                <c:pt idx="45">
                  <c:v>B628</c:v>
                </c:pt>
                <c:pt idx="46">
                  <c:v>B463</c:v>
                </c:pt>
                <c:pt idx="47">
                  <c:v>B463</c:v>
                </c:pt>
                <c:pt idx="48">
                  <c:v>B514</c:v>
                </c:pt>
                <c:pt idx="49">
                  <c:v>B514</c:v>
                </c:pt>
                <c:pt idx="50">
                  <c:v>B606</c:v>
                </c:pt>
                <c:pt idx="51">
                  <c:v>B606</c:v>
                </c:pt>
                <c:pt idx="52">
                  <c:v>B657</c:v>
                </c:pt>
                <c:pt idx="53">
                  <c:v>B657</c:v>
                </c:pt>
                <c:pt idx="54">
                  <c:v>B503</c:v>
                </c:pt>
                <c:pt idx="55">
                  <c:v>B503</c:v>
                </c:pt>
              </c:strCache>
            </c:strRef>
          </c:cat>
          <c:val>
            <c:numRef>
              <c:f>Sheet1!$B$7:$BE$7</c:f>
              <c:numCache>
                <c:formatCode>General</c:formatCode>
                <c:ptCount val="56"/>
                <c:pt idx="0">
                  <c:v>269.39299999999997</c:v>
                </c:pt>
                <c:pt idx="1">
                  <c:v>352.01600000000002</c:v>
                </c:pt>
                <c:pt idx="2">
                  <c:v>793.87599999999998</c:v>
                </c:pt>
                <c:pt idx="3">
                  <c:v>857.21799999999996</c:v>
                </c:pt>
                <c:pt idx="4">
                  <c:v>936.26099999999997</c:v>
                </c:pt>
                <c:pt idx="5">
                  <c:v>1060.558</c:v>
                </c:pt>
                <c:pt idx="6">
                  <c:v>427.47300000000001</c:v>
                </c:pt>
                <c:pt idx="7">
                  <c:v>935.67899999999997</c:v>
                </c:pt>
                <c:pt idx="8">
                  <c:v>951.35900000000004</c:v>
                </c:pt>
                <c:pt idx="9">
                  <c:v>1004.0890000000001</c:v>
                </c:pt>
                <c:pt idx="10">
                  <c:v>2115.7600000000002</c:v>
                </c:pt>
                <c:pt idx="11">
                  <c:v>1743.06</c:v>
                </c:pt>
                <c:pt idx="12">
                  <c:v>340.82799999999997</c:v>
                </c:pt>
                <c:pt idx="13">
                  <c:v>540.14300000000003</c:v>
                </c:pt>
                <c:pt idx="14">
                  <c:v>333.65100000000001</c:v>
                </c:pt>
                <c:pt idx="15">
                  <c:v>446.87700000000001</c:v>
                </c:pt>
                <c:pt idx="16">
                  <c:v>1333.2929999999999</c:v>
                </c:pt>
                <c:pt idx="17">
                  <c:v>1364.758</c:v>
                </c:pt>
                <c:pt idx="18">
                  <c:v>468.10599999999999</c:v>
                </c:pt>
                <c:pt idx="19">
                  <c:v>607.73400000000004</c:v>
                </c:pt>
                <c:pt idx="20">
                  <c:v>732.33699999999999</c:v>
                </c:pt>
                <c:pt idx="21">
                  <c:v>823.84</c:v>
                </c:pt>
                <c:pt idx="22">
                  <c:v>1902.2950000000001</c:v>
                </c:pt>
                <c:pt idx="23">
                  <c:v>2263.7469999999998</c:v>
                </c:pt>
                <c:pt idx="24">
                  <c:v>842.553</c:v>
                </c:pt>
                <c:pt idx="25">
                  <c:v>1083.8150000000001</c:v>
                </c:pt>
                <c:pt idx="26">
                  <c:v>977.18200000000002</c:v>
                </c:pt>
                <c:pt idx="27">
                  <c:v>817.17899999999997</c:v>
                </c:pt>
                <c:pt idx="28">
                  <c:v>167.99100000000001</c:v>
                </c:pt>
                <c:pt idx="29">
                  <c:v>815.82399999999996</c:v>
                </c:pt>
                <c:pt idx="30">
                  <c:v>1049.758</c:v>
                </c:pt>
                <c:pt idx="31">
                  <c:v>790.55899999999997</c:v>
                </c:pt>
                <c:pt idx="32">
                  <c:v>609.78899999999999</c:v>
                </c:pt>
                <c:pt idx="33">
                  <c:v>868.82299999999998</c:v>
                </c:pt>
                <c:pt idx="34">
                  <c:v>823.40499999999997</c:v>
                </c:pt>
                <c:pt idx="35">
                  <c:v>1035.8140000000001</c:v>
                </c:pt>
                <c:pt idx="36">
                  <c:v>1399.223</c:v>
                </c:pt>
                <c:pt idx="37">
                  <c:v>1282.751</c:v>
                </c:pt>
                <c:pt idx="38">
                  <c:v>1111.498</c:v>
                </c:pt>
                <c:pt idx="39">
                  <c:v>1717.6289999999999</c:v>
                </c:pt>
                <c:pt idx="40">
                  <c:v>1478.21</c:v>
                </c:pt>
                <c:pt idx="41">
                  <c:v>1700.0050000000001</c:v>
                </c:pt>
                <c:pt idx="42">
                  <c:v>338.90199999999999</c:v>
                </c:pt>
                <c:pt idx="43">
                  <c:v>681.25099999999998</c:v>
                </c:pt>
                <c:pt idx="44">
                  <c:v>825.80200000000002</c:v>
                </c:pt>
                <c:pt idx="45">
                  <c:v>1098.547</c:v>
                </c:pt>
                <c:pt idx="46">
                  <c:v>382.48899999999998</c:v>
                </c:pt>
                <c:pt idx="47">
                  <c:v>401.851</c:v>
                </c:pt>
                <c:pt idx="48">
                  <c:v>632.54700000000003</c:v>
                </c:pt>
                <c:pt idx="49">
                  <c:v>610.51</c:v>
                </c:pt>
                <c:pt idx="50">
                  <c:v>257.01600000000002</c:v>
                </c:pt>
                <c:pt idx="51">
                  <c:v>279.52300000000002</c:v>
                </c:pt>
                <c:pt idx="52">
                  <c:v>313.47399999999999</c:v>
                </c:pt>
                <c:pt idx="53">
                  <c:v>300.20800000000003</c:v>
                </c:pt>
                <c:pt idx="54">
                  <c:v>807.77200000000005</c:v>
                </c:pt>
                <c:pt idx="55">
                  <c:v>930.835000000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8-34A3-4556-867C-5676E9CF06F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"/>
        <c:overlap val="-27"/>
        <c:axId val="843511712"/>
        <c:axId val="843512040"/>
      </c:barChart>
      <c:catAx>
        <c:axId val="8435117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43512040"/>
        <c:crosses val="autoZero"/>
        <c:auto val="1"/>
        <c:lblAlgn val="ctr"/>
        <c:lblOffset val="100"/>
        <c:noMultiLvlLbl val="0"/>
      </c:catAx>
      <c:valAx>
        <c:axId val="8435120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43511712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AU"/>
              <a:t>LOC10705199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val>
            <c:numRef>
              <c:f>'Spleen RNAseq data-filtered'!$G$9647:$W$9647</c:f>
              <c:numCache>
                <c:formatCode>General</c:formatCode>
                <c:ptCount val="17"/>
                <c:pt idx="0">
                  <c:v>219.35</c:v>
                </c:pt>
                <c:pt idx="1">
                  <c:v>265.38299999999998</c:v>
                </c:pt>
                <c:pt idx="2">
                  <c:v>0</c:v>
                </c:pt>
                <c:pt idx="3">
                  <c:v>218.28100000000001</c:v>
                </c:pt>
                <c:pt idx="4">
                  <c:v>266.49299999999999</c:v>
                </c:pt>
                <c:pt idx="5">
                  <c:v>20.75</c:v>
                </c:pt>
                <c:pt idx="6">
                  <c:v>32.621000000000002</c:v>
                </c:pt>
                <c:pt idx="7">
                  <c:v>34.128</c:v>
                </c:pt>
                <c:pt idx="8">
                  <c:v>242.696</c:v>
                </c:pt>
                <c:pt idx="9">
                  <c:v>16.463999999999999</c:v>
                </c:pt>
                <c:pt idx="10">
                  <c:v>320.887</c:v>
                </c:pt>
                <c:pt idx="11">
                  <c:v>0</c:v>
                </c:pt>
                <c:pt idx="12">
                  <c:v>608.79300000000001</c:v>
                </c:pt>
                <c:pt idx="13">
                  <c:v>0</c:v>
                </c:pt>
                <c:pt idx="14">
                  <c:v>460.77100000000002</c:v>
                </c:pt>
                <c:pt idx="15">
                  <c:v>27.413</c:v>
                </c:pt>
                <c:pt idx="16">
                  <c:v>30.9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801-497F-8500-3C1DC76BDC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27"/>
        <c:axId val="820525848"/>
        <c:axId val="820527488"/>
      </c:barChart>
      <c:catAx>
        <c:axId val="8205258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20527488"/>
        <c:crosses val="autoZero"/>
        <c:auto val="1"/>
        <c:lblAlgn val="ctr"/>
        <c:lblOffset val="100"/>
        <c:noMultiLvlLbl val="0"/>
      </c:catAx>
      <c:valAx>
        <c:axId val="8205274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20525848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AU"/>
              <a:t>IL4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val>
            <c:numRef>
              <c:f>'Spleen RNAseq data-filtered'!$G$4957:$W$4957</c:f>
              <c:numCache>
                <c:formatCode>General</c:formatCode>
                <c:ptCount val="17"/>
                <c:pt idx="0">
                  <c:v>0.997</c:v>
                </c:pt>
                <c:pt idx="1">
                  <c:v>29.920999999999999</c:v>
                </c:pt>
                <c:pt idx="2">
                  <c:v>18.385000000000002</c:v>
                </c:pt>
                <c:pt idx="3">
                  <c:v>31.838000000000001</c:v>
                </c:pt>
                <c:pt idx="4">
                  <c:v>31.672999999999998</c:v>
                </c:pt>
                <c:pt idx="5">
                  <c:v>33.03</c:v>
                </c:pt>
                <c:pt idx="6">
                  <c:v>16.690999999999999</c:v>
                </c:pt>
                <c:pt idx="7">
                  <c:v>21.259</c:v>
                </c:pt>
                <c:pt idx="8">
                  <c:v>16.170999999999999</c:v>
                </c:pt>
                <c:pt idx="9">
                  <c:v>0</c:v>
                </c:pt>
                <c:pt idx="10">
                  <c:v>13.180999999999999</c:v>
                </c:pt>
                <c:pt idx="11">
                  <c:v>27.986000000000001</c:v>
                </c:pt>
                <c:pt idx="12">
                  <c:v>31.678999999999998</c:v>
                </c:pt>
                <c:pt idx="13">
                  <c:v>25.47</c:v>
                </c:pt>
                <c:pt idx="14">
                  <c:v>0.123</c:v>
                </c:pt>
                <c:pt idx="15">
                  <c:v>13.551</c:v>
                </c:pt>
                <c:pt idx="16">
                  <c:v>15.8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262-4B6D-B566-399BAFF6EB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27"/>
        <c:axId val="672054000"/>
        <c:axId val="672054656"/>
      </c:barChart>
      <c:catAx>
        <c:axId val="6720540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72054656"/>
        <c:crosses val="autoZero"/>
        <c:auto val="1"/>
        <c:lblAlgn val="ctr"/>
        <c:lblOffset val="100"/>
        <c:noMultiLvlLbl val="0"/>
      </c:catAx>
      <c:valAx>
        <c:axId val="67205465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72054000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AU"/>
              <a:t>MAFF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val>
            <c:numRef>
              <c:f>'Spleen RNAseq data-filtered'!$H$7293:$W$7293</c:f>
              <c:numCache>
                <c:formatCode>General</c:formatCode>
                <c:ptCount val="16"/>
                <c:pt idx="0">
                  <c:v>0.311</c:v>
                </c:pt>
                <c:pt idx="1">
                  <c:v>23.251999999999999</c:v>
                </c:pt>
                <c:pt idx="2">
                  <c:v>0.52500000000000002</c:v>
                </c:pt>
                <c:pt idx="3">
                  <c:v>19.693000000000001</c:v>
                </c:pt>
                <c:pt idx="4">
                  <c:v>0.14699999999999999</c:v>
                </c:pt>
                <c:pt idx="5">
                  <c:v>0.30199999999999999</c:v>
                </c:pt>
                <c:pt idx="6">
                  <c:v>26.219000000000001</c:v>
                </c:pt>
                <c:pt idx="7">
                  <c:v>56.197000000000003</c:v>
                </c:pt>
                <c:pt idx="8">
                  <c:v>0.33300000000000002</c:v>
                </c:pt>
                <c:pt idx="9">
                  <c:v>27.933</c:v>
                </c:pt>
                <c:pt idx="10">
                  <c:v>55.392000000000003</c:v>
                </c:pt>
                <c:pt idx="11">
                  <c:v>53.688000000000002</c:v>
                </c:pt>
                <c:pt idx="12">
                  <c:v>27.052</c:v>
                </c:pt>
                <c:pt idx="13">
                  <c:v>0.68300000000000005</c:v>
                </c:pt>
                <c:pt idx="14">
                  <c:v>64.436000000000007</c:v>
                </c:pt>
                <c:pt idx="15">
                  <c:v>54.643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6B8-4E00-AF29-947293B1134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27"/>
        <c:axId val="649992072"/>
        <c:axId val="649994696"/>
      </c:barChart>
      <c:catAx>
        <c:axId val="6499920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49994696"/>
        <c:crosses val="autoZero"/>
        <c:auto val="1"/>
        <c:lblAlgn val="ctr"/>
        <c:lblOffset val="100"/>
        <c:noMultiLvlLbl val="0"/>
      </c:catAx>
      <c:valAx>
        <c:axId val="64999469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49992072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AU"/>
              <a:t>GNA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val>
            <c:numRef>
              <c:f>'Spleen RNAseq data-filtered'!$G$5377:$W$5377</c:f>
              <c:numCache>
                <c:formatCode>General</c:formatCode>
                <c:ptCount val="17"/>
                <c:pt idx="0">
                  <c:v>0.16700000000000001</c:v>
                </c:pt>
                <c:pt idx="1">
                  <c:v>22.085000000000001</c:v>
                </c:pt>
                <c:pt idx="2">
                  <c:v>20.852</c:v>
                </c:pt>
                <c:pt idx="3">
                  <c:v>8.8859999999999992</c:v>
                </c:pt>
                <c:pt idx="4">
                  <c:v>30.405000000000001</c:v>
                </c:pt>
                <c:pt idx="5">
                  <c:v>14.207000000000001</c:v>
                </c:pt>
                <c:pt idx="6">
                  <c:v>12.529</c:v>
                </c:pt>
                <c:pt idx="7">
                  <c:v>26.71</c:v>
                </c:pt>
                <c:pt idx="8">
                  <c:v>8.4149999999999991</c:v>
                </c:pt>
                <c:pt idx="9">
                  <c:v>19.484999999999999</c:v>
                </c:pt>
                <c:pt idx="10">
                  <c:v>19.984000000000002</c:v>
                </c:pt>
                <c:pt idx="11">
                  <c:v>19.137</c:v>
                </c:pt>
                <c:pt idx="12">
                  <c:v>36.484000000000002</c:v>
                </c:pt>
                <c:pt idx="13">
                  <c:v>1.3089999999999999</c:v>
                </c:pt>
                <c:pt idx="14">
                  <c:v>20.733000000000001</c:v>
                </c:pt>
                <c:pt idx="15">
                  <c:v>6.2869999999999999</c:v>
                </c:pt>
                <c:pt idx="16">
                  <c:v>29.978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ABE-414F-AB7D-76782E5DFB0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27"/>
        <c:axId val="673806712"/>
        <c:axId val="673806056"/>
      </c:barChart>
      <c:catAx>
        <c:axId val="6738067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73806056"/>
        <c:crosses val="autoZero"/>
        <c:auto val="1"/>
        <c:lblAlgn val="ctr"/>
        <c:lblOffset val="100"/>
        <c:noMultiLvlLbl val="0"/>
      </c:catAx>
      <c:valAx>
        <c:axId val="67380605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73806712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AU"/>
              <a:t>ISL2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val>
            <c:numRef>
              <c:f>'Spleen RNAseq data-filtered'!$G$7526:$W$7526</c:f>
              <c:numCache>
                <c:formatCode>General</c:formatCode>
                <c:ptCount val="17"/>
                <c:pt idx="0">
                  <c:v>69.941000000000003</c:v>
                </c:pt>
                <c:pt idx="1">
                  <c:v>48.317999999999998</c:v>
                </c:pt>
                <c:pt idx="2">
                  <c:v>51.743000000000002</c:v>
                </c:pt>
                <c:pt idx="3">
                  <c:v>49.064</c:v>
                </c:pt>
                <c:pt idx="4">
                  <c:v>54.634</c:v>
                </c:pt>
                <c:pt idx="5">
                  <c:v>17.654</c:v>
                </c:pt>
                <c:pt idx="6">
                  <c:v>7.5830000000000002</c:v>
                </c:pt>
                <c:pt idx="7">
                  <c:v>8.9879999999999995</c:v>
                </c:pt>
                <c:pt idx="8">
                  <c:v>6.9749999999999996</c:v>
                </c:pt>
                <c:pt idx="9">
                  <c:v>67.572000000000003</c:v>
                </c:pt>
                <c:pt idx="10">
                  <c:v>5.8460000000000001</c:v>
                </c:pt>
                <c:pt idx="11">
                  <c:v>37.664999999999999</c:v>
                </c:pt>
                <c:pt idx="12">
                  <c:v>35.656999999999996</c:v>
                </c:pt>
                <c:pt idx="13">
                  <c:v>48.286999999999999</c:v>
                </c:pt>
                <c:pt idx="14">
                  <c:v>38.603999999999999</c:v>
                </c:pt>
                <c:pt idx="15">
                  <c:v>10.983000000000001</c:v>
                </c:pt>
                <c:pt idx="16">
                  <c:v>9.70700000000000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8E9-48DC-8F01-479E7BFA4F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27"/>
        <c:axId val="657144512"/>
        <c:axId val="657141888"/>
      </c:barChart>
      <c:catAx>
        <c:axId val="6571445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57141888"/>
        <c:crosses val="autoZero"/>
        <c:auto val="1"/>
        <c:lblAlgn val="ctr"/>
        <c:lblOffset val="100"/>
        <c:noMultiLvlLbl val="0"/>
      </c:catAx>
      <c:valAx>
        <c:axId val="6571418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57144512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AU"/>
              <a:t>PSPH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val>
            <c:numRef>
              <c:f>'Spleen RNAseq data-filtered'!$G$8574:$W$8574</c:f>
              <c:numCache>
                <c:formatCode>General</c:formatCode>
                <c:ptCount val="17"/>
                <c:pt idx="0">
                  <c:v>35.796999999999997</c:v>
                </c:pt>
                <c:pt idx="1">
                  <c:v>12.558</c:v>
                </c:pt>
                <c:pt idx="2">
                  <c:v>8.5540000000000003</c:v>
                </c:pt>
                <c:pt idx="3">
                  <c:v>9.798</c:v>
                </c:pt>
                <c:pt idx="4">
                  <c:v>11.273</c:v>
                </c:pt>
                <c:pt idx="5">
                  <c:v>10.586</c:v>
                </c:pt>
                <c:pt idx="6">
                  <c:v>115.151</c:v>
                </c:pt>
                <c:pt idx="7">
                  <c:v>14.211</c:v>
                </c:pt>
                <c:pt idx="8">
                  <c:v>17.62</c:v>
                </c:pt>
                <c:pt idx="9">
                  <c:v>11.22</c:v>
                </c:pt>
                <c:pt idx="10">
                  <c:v>8.69</c:v>
                </c:pt>
                <c:pt idx="11">
                  <c:v>10.986000000000001</c:v>
                </c:pt>
                <c:pt idx="12">
                  <c:v>9.157</c:v>
                </c:pt>
                <c:pt idx="13">
                  <c:v>12.54</c:v>
                </c:pt>
                <c:pt idx="14">
                  <c:v>15.368</c:v>
                </c:pt>
                <c:pt idx="15">
                  <c:v>13.314</c:v>
                </c:pt>
                <c:pt idx="16">
                  <c:v>9.19100000000000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8CE-4A6A-B56D-21209D6D589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27"/>
        <c:axId val="648997816"/>
        <c:axId val="648998472"/>
      </c:barChart>
      <c:catAx>
        <c:axId val="6489978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48998472"/>
        <c:crosses val="autoZero"/>
        <c:auto val="1"/>
        <c:lblAlgn val="ctr"/>
        <c:lblOffset val="100"/>
        <c:noMultiLvlLbl val="0"/>
      </c:catAx>
      <c:valAx>
        <c:axId val="6489984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48997816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ENSGALG00000028304</a:t>
            </a:r>
          </a:p>
          <a:p>
            <a:pPr>
              <a:defRPr/>
            </a:pPr>
            <a:r>
              <a:rPr lang="en-AU" sz="1400" b="0" i="0" u="none" strike="noStrike" baseline="0" dirty="0">
                <a:effectLst/>
              </a:rPr>
              <a:t>(MMR1L4)</a:t>
            </a:r>
            <a:endParaRPr lang="en-US" dirty="0"/>
          </a:p>
        </c:rich>
      </c:tx>
      <c:layout>
        <c:manualLayout>
          <c:xMode val="edge"/>
          <c:yMode val="edge"/>
          <c:x val="0.36088773713412403"/>
          <c:y val="4.499993117528582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AE95-4C51-BFE0-028246B001EC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AE95-4C51-BFE0-028246B001EC}"/>
              </c:ext>
            </c:extLst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AE95-4C51-BFE0-028246B001EC}"/>
              </c:ext>
            </c:extLst>
          </c:dPt>
          <c:dPt>
            <c:idx val="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AE95-4C51-BFE0-028246B001EC}"/>
              </c:ext>
            </c:extLst>
          </c:dPt>
          <c:dPt>
            <c:idx val="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AE95-4C51-BFE0-028246B001EC}"/>
              </c:ext>
            </c:extLst>
          </c:dPt>
          <c:dPt>
            <c:idx val="1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AE95-4C51-BFE0-028246B001EC}"/>
              </c:ext>
            </c:extLst>
          </c:dPt>
          <c:dPt>
            <c:idx val="1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AE95-4C51-BFE0-028246B001EC}"/>
              </c:ext>
            </c:extLst>
          </c:dPt>
          <c:dPt>
            <c:idx val="1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AE95-4C51-BFE0-028246B001EC}"/>
              </c:ext>
            </c:extLst>
          </c:dPt>
          <c:dPt>
            <c:idx val="1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AE95-4C51-BFE0-028246B001EC}"/>
              </c:ext>
            </c:extLst>
          </c:dPt>
          <c:dPt>
            <c:idx val="1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3-AE95-4C51-BFE0-028246B001EC}"/>
              </c:ext>
            </c:extLst>
          </c:dPt>
          <c:dPt>
            <c:idx val="2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5-AE95-4C51-BFE0-028246B001EC}"/>
              </c:ext>
            </c:extLst>
          </c:dPt>
          <c:dPt>
            <c:idx val="2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7-AE95-4C51-BFE0-028246B001EC}"/>
              </c:ext>
            </c:extLst>
          </c:dPt>
          <c:dPt>
            <c:idx val="2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9-AE95-4C51-BFE0-028246B001EC}"/>
              </c:ext>
            </c:extLst>
          </c:dPt>
          <c:dPt>
            <c:idx val="2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B-AE95-4C51-BFE0-028246B001EC}"/>
              </c:ext>
            </c:extLst>
          </c:dPt>
          <c:dPt>
            <c:idx val="2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D-AE95-4C51-BFE0-028246B001EC}"/>
              </c:ext>
            </c:extLst>
          </c:dPt>
          <c:dPt>
            <c:idx val="3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F-AE95-4C51-BFE0-028246B001EC}"/>
              </c:ext>
            </c:extLst>
          </c:dPt>
          <c:dPt>
            <c:idx val="3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1-AE95-4C51-BFE0-028246B001EC}"/>
              </c:ext>
            </c:extLst>
          </c:dPt>
          <c:dPt>
            <c:idx val="3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3-AE95-4C51-BFE0-028246B001EC}"/>
              </c:ext>
            </c:extLst>
          </c:dPt>
          <c:dPt>
            <c:idx val="3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5-AE95-4C51-BFE0-028246B001EC}"/>
              </c:ext>
            </c:extLst>
          </c:dPt>
          <c:dPt>
            <c:idx val="3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7-AE95-4C51-BFE0-028246B001EC}"/>
              </c:ext>
            </c:extLst>
          </c:dPt>
          <c:dPt>
            <c:idx val="4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9-AE95-4C51-BFE0-028246B001EC}"/>
              </c:ext>
            </c:extLst>
          </c:dPt>
          <c:dPt>
            <c:idx val="4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B-AE95-4C51-BFE0-028246B001EC}"/>
              </c:ext>
            </c:extLst>
          </c:dPt>
          <c:dPt>
            <c:idx val="4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D-AE95-4C51-BFE0-028246B001EC}"/>
              </c:ext>
            </c:extLst>
          </c:dPt>
          <c:dPt>
            <c:idx val="4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F-AE95-4C51-BFE0-028246B001EC}"/>
              </c:ext>
            </c:extLst>
          </c:dPt>
          <c:dPt>
            <c:idx val="4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1-AE95-4C51-BFE0-028246B001EC}"/>
              </c:ext>
            </c:extLst>
          </c:dPt>
          <c:dPt>
            <c:idx val="5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3-AE95-4C51-BFE0-028246B001EC}"/>
              </c:ext>
            </c:extLst>
          </c:dPt>
          <c:dPt>
            <c:idx val="5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5-AE95-4C51-BFE0-028246B001EC}"/>
              </c:ext>
            </c:extLst>
          </c:dPt>
          <c:dPt>
            <c:idx val="5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7-AE95-4C51-BFE0-028246B001EC}"/>
              </c:ext>
            </c:extLst>
          </c:dPt>
          <c:cat>
            <c:strRef>
              <c:f>Sheet1!$B$1:$BE$1</c:f>
              <c:strCache>
                <c:ptCount val="56"/>
                <c:pt idx="0">
                  <c:v>B510</c:v>
                </c:pt>
                <c:pt idx="1">
                  <c:v>B510</c:v>
                </c:pt>
                <c:pt idx="2">
                  <c:v>B459</c:v>
                </c:pt>
                <c:pt idx="3">
                  <c:v>B459</c:v>
                </c:pt>
                <c:pt idx="4">
                  <c:v>B512</c:v>
                </c:pt>
                <c:pt idx="5">
                  <c:v>B512</c:v>
                </c:pt>
                <c:pt idx="6">
                  <c:v>B513</c:v>
                </c:pt>
                <c:pt idx="7">
                  <c:v>B513</c:v>
                </c:pt>
                <c:pt idx="8">
                  <c:v>B540</c:v>
                </c:pt>
                <c:pt idx="9">
                  <c:v>B540</c:v>
                </c:pt>
                <c:pt idx="10">
                  <c:v>B541</c:v>
                </c:pt>
                <c:pt idx="11">
                  <c:v>B541</c:v>
                </c:pt>
                <c:pt idx="12">
                  <c:v>B542</c:v>
                </c:pt>
                <c:pt idx="13">
                  <c:v>B542</c:v>
                </c:pt>
                <c:pt idx="14">
                  <c:v>B643</c:v>
                </c:pt>
                <c:pt idx="15">
                  <c:v>B643</c:v>
                </c:pt>
                <c:pt idx="16">
                  <c:v>B664</c:v>
                </c:pt>
                <c:pt idx="17">
                  <c:v>B664</c:v>
                </c:pt>
                <c:pt idx="18">
                  <c:v>B666</c:v>
                </c:pt>
                <c:pt idx="19">
                  <c:v>B666</c:v>
                </c:pt>
                <c:pt idx="20">
                  <c:v>B699</c:v>
                </c:pt>
                <c:pt idx="21">
                  <c:v>B699</c:v>
                </c:pt>
                <c:pt idx="22">
                  <c:v>B700</c:v>
                </c:pt>
                <c:pt idx="23">
                  <c:v>B700</c:v>
                </c:pt>
                <c:pt idx="24">
                  <c:v>B701</c:v>
                </c:pt>
                <c:pt idx="25">
                  <c:v>B701</c:v>
                </c:pt>
                <c:pt idx="26">
                  <c:v>B702</c:v>
                </c:pt>
                <c:pt idx="27">
                  <c:v>B702</c:v>
                </c:pt>
                <c:pt idx="28">
                  <c:v>B703</c:v>
                </c:pt>
                <c:pt idx="29">
                  <c:v>B703</c:v>
                </c:pt>
                <c:pt idx="30">
                  <c:v>B4292</c:v>
                </c:pt>
                <c:pt idx="31">
                  <c:v>B4292</c:v>
                </c:pt>
                <c:pt idx="32">
                  <c:v>B4293</c:v>
                </c:pt>
                <c:pt idx="33">
                  <c:v>B4293</c:v>
                </c:pt>
                <c:pt idx="34">
                  <c:v>B476</c:v>
                </c:pt>
                <c:pt idx="35">
                  <c:v>B476</c:v>
                </c:pt>
                <c:pt idx="36">
                  <c:v>B477</c:v>
                </c:pt>
                <c:pt idx="37">
                  <c:v>B477</c:v>
                </c:pt>
                <c:pt idx="38">
                  <c:v>B528</c:v>
                </c:pt>
                <c:pt idx="39">
                  <c:v>B528</c:v>
                </c:pt>
                <c:pt idx="40">
                  <c:v>B613</c:v>
                </c:pt>
                <c:pt idx="41">
                  <c:v>B613</c:v>
                </c:pt>
                <c:pt idx="42">
                  <c:v>B614</c:v>
                </c:pt>
                <c:pt idx="43">
                  <c:v>B614</c:v>
                </c:pt>
                <c:pt idx="44">
                  <c:v>B628</c:v>
                </c:pt>
                <c:pt idx="45">
                  <c:v>B628</c:v>
                </c:pt>
                <c:pt idx="46">
                  <c:v>B463</c:v>
                </c:pt>
                <c:pt idx="47">
                  <c:v>B463</c:v>
                </c:pt>
                <c:pt idx="48">
                  <c:v>B514</c:v>
                </c:pt>
                <c:pt idx="49">
                  <c:v>B514</c:v>
                </c:pt>
                <c:pt idx="50">
                  <c:v>B606</c:v>
                </c:pt>
                <c:pt idx="51">
                  <c:v>B606</c:v>
                </c:pt>
                <c:pt idx="52">
                  <c:v>B657</c:v>
                </c:pt>
                <c:pt idx="53">
                  <c:v>B657</c:v>
                </c:pt>
                <c:pt idx="54">
                  <c:v>B503</c:v>
                </c:pt>
                <c:pt idx="55">
                  <c:v>B503</c:v>
                </c:pt>
              </c:strCache>
            </c:strRef>
          </c:cat>
          <c:val>
            <c:numRef>
              <c:f>Sheet1!$B$5:$BE$5</c:f>
              <c:numCache>
                <c:formatCode>General</c:formatCode>
                <c:ptCount val="56"/>
                <c:pt idx="0">
                  <c:v>12.106</c:v>
                </c:pt>
                <c:pt idx="1">
                  <c:v>2.5190000000000001</c:v>
                </c:pt>
                <c:pt idx="2">
                  <c:v>38.996000000000002</c:v>
                </c:pt>
                <c:pt idx="3">
                  <c:v>15.875999999999999</c:v>
                </c:pt>
                <c:pt idx="4">
                  <c:v>23.503</c:v>
                </c:pt>
                <c:pt idx="5">
                  <c:v>22.713000000000001</c:v>
                </c:pt>
                <c:pt idx="6">
                  <c:v>29.46</c:v>
                </c:pt>
                <c:pt idx="7">
                  <c:v>5.1429999999999998</c:v>
                </c:pt>
                <c:pt idx="8">
                  <c:v>29.442</c:v>
                </c:pt>
                <c:pt idx="9">
                  <c:v>18.876000000000001</c:v>
                </c:pt>
                <c:pt idx="10">
                  <c:v>23.294</c:v>
                </c:pt>
                <c:pt idx="11">
                  <c:v>24.963000000000001</c:v>
                </c:pt>
                <c:pt idx="12">
                  <c:v>25.952000000000002</c:v>
                </c:pt>
                <c:pt idx="13">
                  <c:v>16.899000000000001</c:v>
                </c:pt>
                <c:pt idx="14">
                  <c:v>19.783000000000001</c:v>
                </c:pt>
                <c:pt idx="15">
                  <c:v>22.013000000000002</c:v>
                </c:pt>
                <c:pt idx="16">
                  <c:v>30.213999999999999</c:v>
                </c:pt>
                <c:pt idx="17">
                  <c:v>16.472999999999999</c:v>
                </c:pt>
                <c:pt idx="18">
                  <c:v>25.881</c:v>
                </c:pt>
                <c:pt idx="19">
                  <c:v>17.533999999999999</c:v>
                </c:pt>
                <c:pt idx="20">
                  <c:v>28.663</c:v>
                </c:pt>
                <c:pt idx="21">
                  <c:v>13.797000000000001</c:v>
                </c:pt>
                <c:pt idx="22">
                  <c:v>35.146999999999998</c:v>
                </c:pt>
                <c:pt idx="23">
                  <c:v>26.895</c:v>
                </c:pt>
                <c:pt idx="24">
                  <c:v>22.103999999999999</c:v>
                </c:pt>
                <c:pt idx="25">
                  <c:v>14.071</c:v>
                </c:pt>
                <c:pt idx="26">
                  <c:v>32.601999999999997</c:v>
                </c:pt>
                <c:pt idx="27">
                  <c:v>20.317</c:v>
                </c:pt>
                <c:pt idx="28">
                  <c:v>23.247</c:v>
                </c:pt>
                <c:pt idx="29">
                  <c:v>1.2030000000000001</c:v>
                </c:pt>
                <c:pt idx="30">
                  <c:v>27.870999999999999</c:v>
                </c:pt>
                <c:pt idx="31">
                  <c:v>25.468</c:v>
                </c:pt>
                <c:pt idx="32">
                  <c:v>31.311</c:v>
                </c:pt>
                <c:pt idx="33">
                  <c:v>12.944000000000001</c:v>
                </c:pt>
                <c:pt idx="34">
                  <c:v>24.268000000000001</c:v>
                </c:pt>
                <c:pt idx="35">
                  <c:v>0.437</c:v>
                </c:pt>
                <c:pt idx="36">
                  <c:v>34.290999999999997</c:v>
                </c:pt>
                <c:pt idx="37">
                  <c:v>44.774000000000001</c:v>
                </c:pt>
                <c:pt idx="38">
                  <c:v>46.619</c:v>
                </c:pt>
                <c:pt idx="39">
                  <c:v>26.667000000000002</c:v>
                </c:pt>
                <c:pt idx="40">
                  <c:v>31.097000000000001</c:v>
                </c:pt>
                <c:pt idx="41">
                  <c:v>1.373</c:v>
                </c:pt>
                <c:pt idx="42">
                  <c:v>29.454999999999998</c:v>
                </c:pt>
                <c:pt idx="43">
                  <c:v>16.134</c:v>
                </c:pt>
                <c:pt idx="44">
                  <c:v>40.500999999999998</c:v>
                </c:pt>
                <c:pt idx="45">
                  <c:v>31.449000000000002</c:v>
                </c:pt>
                <c:pt idx="46">
                  <c:v>18.579000000000001</c:v>
                </c:pt>
                <c:pt idx="47">
                  <c:v>11.709</c:v>
                </c:pt>
                <c:pt idx="48">
                  <c:v>26.327999999999999</c:v>
                </c:pt>
                <c:pt idx="49">
                  <c:v>4.8179999999999996</c:v>
                </c:pt>
                <c:pt idx="50">
                  <c:v>21.51</c:v>
                </c:pt>
                <c:pt idx="51">
                  <c:v>5.7670000000000003</c:v>
                </c:pt>
                <c:pt idx="52">
                  <c:v>20.814</c:v>
                </c:pt>
                <c:pt idx="53">
                  <c:v>6.6639999999999997</c:v>
                </c:pt>
                <c:pt idx="54">
                  <c:v>55.295999999999999</c:v>
                </c:pt>
                <c:pt idx="55">
                  <c:v>28.1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8-AE95-4C51-BFE0-028246B001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"/>
        <c:overlap val="-27"/>
        <c:axId val="843511712"/>
        <c:axId val="843512040"/>
      </c:barChart>
      <c:catAx>
        <c:axId val="8435117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43512040"/>
        <c:crosses val="autoZero"/>
        <c:auto val="1"/>
        <c:lblAlgn val="ctr"/>
        <c:lblOffset val="100"/>
        <c:noMultiLvlLbl val="0"/>
      </c:catAx>
      <c:valAx>
        <c:axId val="8435120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43511712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TLR2A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03F3-4BF8-9904-CA835AC33BCF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03F3-4BF8-9904-CA835AC33BCF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03F3-4BF8-9904-CA835AC33BCF}"/>
              </c:ext>
            </c:extLst>
          </c:dPt>
          <c:dPt>
            <c:idx val="6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03F3-4BF8-9904-CA835AC33BCF}"/>
              </c:ext>
            </c:extLst>
          </c:dPt>
          <c:dPt>
            <c:idx val="8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03F3-4BF8-9904-CA835AC33BCF}"/>
              </c:ext>
            </c:extLst>
          </c:dPt>
          <c:dPt>
            <c:idx val="1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03F3-4BF8-9904-CA835AC33BCF}"/>
              </c:ext>
            </c:extLst>
          </c:dPt>
          <c:dPt>
            <c:idx val="12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03F3-4BF8-9904-CA835AC33BCF}"/>
              </c:ext>
            </c:extLst>
          </c:dPt>
          <c:dPt>
            <c:idx val="14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03F3-4BF8-9904-CA835AC33BCF}"/>
              </c:ext>
            </c:extLst>
          </c:dPt>
          <c:dPt>
            <c:idx val="16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03F3-4BF8-9904-CA835AC33BCF}"/>
              </c:ext>
            </c:extLst>
          </c:dPt>
          <c:dPt>
            <c:idx val="18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3-03F3-4BF8-9904-CA835AC33BCF}"/>
              </c:ext>
            </c:extLst>
          </c:dPt>
          <c:dPt>
            <c:idx val="2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5-03F3-4BF8-9904-CA835AC33BCF}"/>
              </c:ext>
            </c:extLst>
          </c:dPt>
          <c:dPt>
            <c:idx val="22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7-03F3-4BF8-9904-CA835AC33BCF}"/>
              </c:ext>
            </c:extLst>
          </c:dPt>
          <c:dPt>
            <c:idx val="24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9-03F3-4BF8-9904-CA835AC33BCF}"/>
              </c:ext>
            </c:extLst>
          </c:dPt>
          <c:dPt>
            <c:idx val="26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B-03F3-4BF8-9904-CA835AC33BCF}"/>
              </c:ext>
            </c:extLst>
          </c:dPt>
          <c:dPt>
            <c:idx val="28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D-03F3-4BF8-9904-CA835AC33BCF}"/>
              </c:ext>
            </c:extLst>
          </c:dPt>
          <c:dPt>
            <c:idx val="3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F-03F3-4BF8-9904-CA835AC33BCF}"/>
              </c:ext>
            </c:extLst>
          </c:dPt>
          <c:dPt>
            <c:idx val="32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1-03F3-4BF8-9904-CA835AC33BCF}"/>
              </c:ext>
            </c:extLst>
          </c:dPt>
          <c:dPt>
            <c:idx val="34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3-03F3-4BF8-9904-CA835AC33BCF}"/>
              </c:ext>
            </c:extLst>
          </c:dPt>
          <c:dPt>
            <c:idx val="36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5-03F3-4BF8-9904-CA835AC33BCF}"/>
              </c:ext>
            </c:extLst>
          </c:dPt>
          <c:dPt>
            <c:idx val="38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7-03F3-4BF8-9904-CA835AC33BCF}"/>
              </c:ext>
            </c:extLst>
          </c:dPt>
          <c:dPt>
            <c:idx val="4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9-03F3-4BF8-9904-CA835AC33BCF}"/>
              </c:ext>
            </c:extLst>
          </c:dPt>
          <c:dPt>
            <c:idx val="42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B-03F3-4BF8-9904-CA835AC33BCF}"/>
              </c:ext>
            </c:extLst>
          </c:dPt>
          <c:dPt>
            <c:idx val="44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D-03F3-4BF8-9904-CA835AC33BCF}"/>
              </c:ext>
            </c:extLst>
          </c:dPt>
          <c:dPt>
            <c:idx val="46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F-03F3-4BF8-9904-CA835AC33BCF}"/>
              </c:ext>
            </c:extLst>
          </c:dPt>
          <c:dPt>
            <c:idx val="48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1-03F3-4BF8-9904-CA835AC33BCF}"/>
              </c:ext>
            </c:extLst>
          </c:dPt>
          <c:dPt>
            <c:idx val="5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3-03F3-4BF8-9904-CA835AC33BCF}"/>
              </c:ext>
            </c:extLst>
          </c:dPt>
          <c:dPt>
            <c:idx val="52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5-03F3-4BF8-9904-CA835AC33BCF}"/>
              </c:ext>
            </c:extLst>
          </c:dPt>
          <c:cat>
            <c:strRef>
              <c:f>'LPS treatment'!$P$1:$BS$1</c:f>
              <c:strCache>
                <c:ptCount val="56"/>
                <c:pt idx="0">
                  <c:v>B510</c:v>
                </c:pt>
                <c:pt idx="1">
                  <c:v>B510</c:v>
                </c:pt>
                <c:pt idx="2">
                  <c:v>B459</c:v>
                </c:pt>
                <c:pt idx="3">
                  <c:v>B459</c:v>
                </c:pt>
                <c:pt idx="4">
                  <c:v>B512</c:v>
                </c:pt>
                <c:pt idx="5">
                  <c:v>B512</c:v>
                </c:pt>
                <c:pt idx="6">
                  <c:v>B513</c:v>
                </c:pt>
                <c:pt idx="7">
                  <c:v>B513</c:v>
                </c:pt>
                <c:pt idx="8">
                  <c:v>B540</c:v>
                </c:pt>
                <c:pt idx="9">
                  <c:v>B540</c:v>
                </c:pt>
                <c:pt idx="10">
                  <c:v>B541</c:v>
                </c:pt>
                <c:pt idx="11">
                  <c:v>B541</c:v>
                </c:pt>
                <c:pt idx="12">
                  <c:v>B542</c:v>
                </c:pt>
                <c:pt idx="13">
                  <c:v>B542</c:v>
                </c:pt>
                <c:pt idx="14">
                  <c:v>B643</c:v>
                </c:pt>
                <c:pt idx="15">
                  <c:v>B643</c:v>
                </c:pt>
                <c:pt idx="16">
                  <c:v>B664</c:v>
                </c:pt>
                <c:pt idx="17">
                  <c:v>B664</c:v>
                </c:pt>
                <c:pt idx="18">
                  <c:v>B666</c:v>
                </c:pt>
                <c:pt idx="19">
                  <c:v>B666</c:v>
                </c:pt>
                <c:pt idx="20">
                  <c:v>B699</c:v>
                </c:pt>
                <c:pt idx="21">
                  <c:v>B699</c:v>
                </c:pt>
                <c:pt idx="22">
                  <c:v>B700</c:v>
                </c:pt>
                <c:pt idx="23">
                  <c:v>B700</c:v>
                </c:pt>
                <c:pt idx="24">
                  <c:v>B701</c:v>
                </c:pt>
                <c:pt idx="25">
                  <c:v>B701</c:v>
                </c:pt>
                <c:pt idx="26">
                  <c:v>B702</c:v>
                </c:pt>
                <c:pt idx="27">
                  <c:v>B702</c:v>
                </c:pt>
                <c:pt idx="28">
                  <c:v>B703</c:v>
                </c:pt>
                <c:pt idx="29">
                  <c:v>B703</c:v>
                </c:pt>
                <c:pt idx="30">
                  <c:v>B4292</c:v>
                </c:pt>
                <c:pt idx="31">
                  <c:v>B4292</c:v>
                </c:pt>
                <c:pt idx="32">
                  <c:v>B4293</c:v>
                </c:pt>
                <c:pt idx="33">
                  <c:v>B4293</c:v>
                </c:pt>
                <c:pt idx="34">
                  <c:v>B476</c:v>
                </c:pt>
                <c:pt idx="35">
                  <c:v>B476</c:v>
                </c:pt>
                <c:pt idx="36">
                  <c:v>B477</c:v>
                </c:pt>
                <c:pt idx="37">
                  <c:v>B477</c:v>
                </c:pt>
                <c:pt idx="38">
                  <c:v>B528</c:v>
                </c:pt>
                <c:pt idx="39">
                  <c:v>B528</c:v>
                </c:pt>
                <c:pt idx="40">
                  <c:v>B613</c:v>
                </c:pt>
                <c:pt idx="41">
                  <c:v>B613</c:v>
                </c:pt>
                <c:pt idx="42">
                  <c:v>B614</c:v>
                </c:pt>
                <c:pt idx="43">
                  <c:v>B614</c:v>
                </c:pt>
                <c:pt idx="44">
                  <c:v>B628</c:v>
                </c:pt>
                <c:pt idx="45">
                  <c:v>B628</c:v>
                </c:pt>
                <c:pt idx="46">
                  <c:v>B463</c:v>
                </c:pt>
                <c:pt idx="47">
                  <c:v>B463</c:v>
                </c:pt>
                <c:pt idx="48">
                  <c:v>B514</c:v>
                </c:pt>
                <c:pt idx="49">
                  <c:v>B514</c:v>
                </c:pt>
                <c:pt idx="50">
                  <c:v>B606</c:v>
                </c:pt>
                <c:pt idx="51">
                  <c:v>B606</c:v>
                </c:pt>
                <c:pt idx="52">
                  <c:v>B657</c:v>
                </c:pt>
                <c:pt idx="53">
                  <c:v>B657</c:v>
                </c:pt>
                <c:pt idx="54">
                  <c:v>B503</c:v>
                </c:pt>
                <c:pt idx="55">
                  <c:v>B503</c:v>
                </c:pt>
              </c:strCache>
            </c:strRef>
          </c:cat>
          <c:val>
            <c:numRef>
              <c:f>'LPS treatment'!$R$22745:$BS$22745</c:f>
              <c:numCache>
                <c:formatCode>General</c:formatCode>
                <c:ptCount val="54"/>
                <c:pt idx="0">
                  <c:v>67.328999999999994</c:v>
                </c:pt>
                <c:pt idx="1">
                  <c:v>43.456000000000003</c:v>
                </c:pt>
                <c:pt idx="2">
                  <c:v>62.823</c:v>
                </c:pt>
                <c:pt idx="3">
                  <c:v>81.378</c:v>
                </c:pt>
                <c:pt idx="4">
                  <c:v>60.878999999999998</c:v>
                </c:pt>
                <c:pt idx="5">
                  <c:v>5.2140000000000004</c:v>
                </c:pt>
                <c:pt idx="6">
                  <c:v>78.983000000000004</c:v>
                </c:pt>
                <c:pt idx="7">
                  <c:v>55.262</c:v>
                </c:pt>
                <c:pt idx="8">
                  <c:v>42.021000000000001</c:v>
                </c:pt>
                <c:pt idx="9">
                  <c:v>46.655000000000001</c:v>
                </c:pt>
                <c:pt idx="10">
                  <c:v>48.046999999999997</c:v>
                </c:pt>
                <c:pt idx="11">
                  <c:v>30.213000000000001</c:v>
                </c:pt>
                <c:pt idx="12">
                  <c:v>29.815000000000001</c:v>
                </c:pt>
                <c:pt idx="13">
                  <c:v>44.281999999999996</c:v>
                </c:pt>
                <c:pt idx="14">
                  <c:v>58.762</c:v>
                </c:pt>
                <c:pt idx="15">
                  <c:v>53.66</c:v>
                </c:pt>
                <c:pt idx="16">
                  <c:v>52.750999999999998</c:v>
                </c:pt>
                <c:pt idx="17">
                  <c:v>25.303000000000001</c:v>
                </c:pt>
                <c:pt idx="18">
                  <c:v>51.56</c:v>
                </c:pt>
                <c:pt idx="19">
                  <c:v>17.417999999999999</c:v>
                </c:pt>
                <c:pt idx="20">
                  <c:v>68.156000000000006</c:v>
                </c:pt>
                <c:pt idx="21">
                  <c:v>65.097999999999999</c:v>
                </c:pt>
                <c:pt idx="22">
                  <c:v>46.462000000000003</c:v>
                </c:pt>
                <c:pt idx="23">
                  <c:v>26.003</c:v>
                </c:pt>
                <c:pt idx="24">
                  <c:v>71.792000000000002</c:v>
                </c:pt>
                <c:pt idx="25">
                  <c:v>64.025999999999996</c:v>
                </c:pt>
                <c:pt idx="26">
                  <c:v>45.924999999999997</c:v>
                </c:pt>
                <c:pt idx="27">
                  <c:v>19.843</c:v>
                </c:pt>
                <c:pt idx="28">
                  <c:v>45.396000000000001</c:v>
                </c:pt>
                <c:pt idx="29">
                  <c:v>53.773000000000003</c:v>
                </c:pt>
                <c:pt idx="30">
                  <c:v>59.628999999999998</c:v>
                </c:pt>
                <c:pt idx="31">
                  <c:v>38.854999999999997</c:v>
                </c:pt>
                <c:pt idx="32">
                  <c:v>85.762</c:v>
                </c:pt>
                <c:pt idx="33">
                  <c:v>1.02</c:v>
                </c:pt>
                <c:pt idx="34">
                  <c:v>90.515000000000001</c:v>
                </c:pt>
                <c:pt idx="35">
                  <c:v>113.774</c:v>
                </c:pt>
                <c:pt idx="36">
                  <c:v>92.331999999999994</c:v>
                </c:pt>
                <c:pt idx="37">
                  <c:v>81.97</c:v>
                </c:pt>
                <c:pt idx="38">
                  <c:v>100.224</c:v>
                </c:pt>
                <c:pt idx="39">
                  <c:v>3.508</c:v>
                </c:pt>
                <c:pt idx="40">
                  <c:v>62.688000000000002</c:v>
                </c:pt>
                <c:pt idx="41">
                  <c:v>21.683</c:v>
                </c:pt>
                <c:pt idx="42">
                  <c:v>75.650999999999996</c:v>
                </c:pt>
                <c:pt idx="43">
                  <c:v>66.289000000000001</c:v>
                </c:pt>
                <c:pt idx="44">
                  <c:v>14.426</c:v>
                </c:pt>
                <c:pt idx="45">
                  <c:v>10.178000000000001</c:v>
                </c:pt>
                <c:pt idx="46">
                  <c:v>56.427</c:v>
                </c:pt>
                <c:pt idx="47">
                  <c:v>14.250999999999999</c:v>
                </c:pt>
                <c:pt idx="48">
                  <c:v>28.628</c:v>
                </c:pt>
                <c:pt idx="49">
                  <c:v>7.1689999999999996</c:v>
                </c:pt>
                <c:pt idx="50">
                  <c:v>59.954999999999998</c:v>
                </c:pt>
                <c:pt idx="51">
                  <c:v>19.885000000000002</c:v>
                </c:pt>
                <c:pt idx="52">
                  <c:v>56.423000000000002</c:v>
                </c:pt>
                <c:pt idx="53">
                  <c:v>20.268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6-03F3-4BF8-9904-CA835AC33B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"/>
        <c:overlap val="-27"/>
        <c:axId val="456403984"/>
        <c:axId val="456409232"/>
      </c:barChart>
      <c:catAx>
        <c:axId val="4564039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6409232"/>
        <c:crosses val="autoZero"/>
        <c:auto val="1"/>
        <c:lblAlgn val="ctr"/>
        <c:lblOffset val="100"/>
        <c:noMultiLvlLbl val="0"/>
      </c:catAx>
      <c:valAx>
        <c:axId val="4564092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6403984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EAAAB-32AB-46DA-9D9C-3C6EB5F1AD1F}" type="datetimeFigureOut">
              <a:rPr lang="en-AU" smtClean="0"/>
              <a:t>1/7/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47DC8-7DF9-4F8A-A109-5B3657067B2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306376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EAAAB-32AB-46DA-9D9C-3C6EB5F1AD1F}" type="datetimeFigureOut">
              <a:rPr lang="en-AU" smtClean="0"/>
              <a:t>1/7/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47DC8-7DF9-4F8A-A109-5B3657067B2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387407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EAAAB-32AB-46DA-9D9C-3C6EB5F1AD1F}" type="datetimeFigureOut">
              <a:rPr lang="en-AU" smtClean="0"/>
              <a:t>1/7/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47DC8-7DF9-4F8A-A109-5B3657067B2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372856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EAAAB-32AB-46DA-9D9C-3C6EB5F1AD1F}" type="datetimeFigureOut">
              <a:rPr lang="en-AU" smtClean="0"/>
              <a:t>1/7/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47DC8-7DF9-4F8A-A109-5B3657067B2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445844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EAAAB-32AB-46DA-9D9C-3C6EB5F1AD1F}" type="datetimeFigureOut">
              <a:rPr lang="en-AU" smtClean="0"/>
              <a:t>1/7/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47DC8-7DF9-4F8A-A109-5B3657067B2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95133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EAAAB-32AB-46DA-9D9C-3C6EB5F1AD1F}" type="datetimeFigureOut">
              <a:rPr lang="en-AU" smtClean="0"/>
              <a:t>1/7/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47DC8-7DF9-4F8A-A109-5B3657067B2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278236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EAAAB-32AB-46DA-9D9C-3C6EB5F1AD1F}" type="datetimeFigureOut">
              <a:rPr lang="en-AU" smtClean="0"/>
              <a:t>1/7/19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47DC8-7DF9-4F8A-A109-5B3657067B2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609938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EAAAB-32AB-46DA-9D9C-3C6EB5F1AD1F}" type="datetimeFigureOut">
              <a:rPr lang="en-AU" smtClean="0"/>
              <a:t>1/7/19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47DC8-7DF9-4F8A-A109-5B3657067B2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062503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EAAAB-32AB-46DA-9D9C-3C6EB5F1AD1F}" type="datetimeFigureOut">
              <a:rPr lang="en-AU" smtClean="0"/>
              <a:t>1/7/19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47DC8-7DF9-4F8A-A109-5B3657067B2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075866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EAAAB-32AB-46DA-9D9C-3C6EB5F1AD1F}" type="datetimeFigureOut">
              <a:rPr lang="en-AU" smtClean="0"/>
              <a:t>1/7/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47DC8-7DF9-4F8A-A109-5B3657067B2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718919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EAAAB-32AB-46DA-9D9C-3C6EB5F1AD1F}" type="datetimeFigureOut">
              <a:rPr lang="en-AU" smtClean="0"/>
              <a:t>1/7/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47DC8-7DF9-4F8A-A109-5B3657067B2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473845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BEAAAB-32AB-46DA-9D9C-3C6EB5F1AD1F}" type="datetimeFigureOut">
              <a:rPr lang="en-AU" smtClean="0"/>
              <a:t>1/7/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047DC8-7DF9-4F8A-A109-5B3657067B2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278624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7.xml"/><Relationship Id="rId4" Type="http://schemas.openxmlformats.org/officeDocument/2006/relationships/chart" Target="../charts/char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9.xml"/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1.xml"/><Relationship Id="rId2" Type="http://schemas.openxmlformats.org/officeDocument/2006/relationships/chart" Target="../charts/chart10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3.xml"/><Relationship Id="rId2" Type="http://schemas.openxmlformats.org/officeDocument/2006/relationships/chart" Target="../charts/chart12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5.xml"/><Relationship Id="rId2" Type="http://schemas.openxmlformats.org/officeDocument/2006/relationships/chart" Target="../charts/chart14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6C4B8E11-F089-4C4F-9BC8-03EFC929CFD4}"/>
              </a:ext>
            </a:extLst>
          </p:cNvPr>
          <p:cNvSpPr txBox="1">
            <a:spLocks/>
          </p:cNvSpPr>
          <p:nvPr/>
        </p:nvSpPr>
        <p:spPr>
          <a:xfrm>
            <a:off x="238778" y="4195"/>
            <a:ext cx="5360356" cy="859061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AU" sz="1400" b="1" dirty="0"/>
              <a:t>Supplementary Figure S1.</a:t>
            </a:r>
            <a:r>
              <a:rPr lang="en-AU" sz="1200" b="1" dirty="0"/>
              <a:t> </a:t>
            </a:r>
            <a:r>
              <a:rPr lang="en-AU" sz="1200" dirty="0"/>
              <a:t>Expression levels in spleen derived from F2 brother sister mated birds.</a:t>
            </a:r>
            <a:br>
              <a:rPr lang="en-AU" sz="1200" dirty="0"/>
            </a:br>
            <a:r>
              <a:rPr lang="en-AU" sz="1200" dirty="0"/>
              <a:t> X axis shows the individual IDs; Y axis shows the expression level (TPM) of 24 – 48 hour hatchling birds.</a:t>
            </a:r>
            <a:endParaRPr lang="en-AU" sz="1200" b="1" dirty="0"/>
          </a:p>
        </p:txBody>
      </p:sp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7168C635-627A-4145-BF4A-AB6D8714A96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05694326"/>
              </p:ext>
            </p:extLst>
          </p:nvPr>
        </p:nvGraphicFramePr>
        <p:xfrm>
          <a:off x="1503123" y="1123169"/>
          <a:ext cx="3529626" cy="23799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F6BC0E91-28EE-4918-8273-2248081D24D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21365123"/>
              </p:ext>
            </p:extLst>
          </p:nvPr>
        </p:nvGraphicFramePr>
        <p:xfrm>
          <a:off x="1500409" y="3763027"/>
          <a:ext cx="3529626" cy="23799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DF935D56-2F33-4C4F-801D-C7AE5AEA564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47349697"/>
              </p:ext>
            </p:extLst>
          </p:nvPr>
        </p:nvGraphicFramePr>
        <p:xfrm>
          <a:off x="1500409" y="6402886"/>
          <a:ext cx="3529626" cy="23799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40811408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92F38723-1D05-4918-9D64-625BCAE0970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17040983"/>
              </p:ext>
            </p:extLst>
          </p:nvPr>
        </p:nvGraphicFramePr>
        <p:xfrm>
          <a:off x="1499574" y="0"/>
          <a:ext cx="3529626" cy="23799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AD734891-615F-4707-BCA2-F06584DEB24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96345708"/>
              </p:ext>
            </p:extLst>
          </p:nvPr>
        </p:nvGraphicFramePr>
        <p:xfrm>
          <a:off x="1499574" y="2510656"/>
          <a:ext cx="3529626" cy="23799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61AC3AA0-7694-48BF-B4FB-B3C2EF59315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47008619"/>
              </p:ext>
            </p:extLst>
          </p:nvPr>
        </p:nvGraphicFramePr>
        <p:xfrm>
          <a:off x="1499574" y="5021312"/>
          <a:ext cx="3529626" cy="23799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64FE7E63-34F0-46E3-8D73-7AE4A2D6504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20284715"/>
              </p:ext>
            </p:extLst>
          </p:nvPr>
        </p:nvGraphicFramePr>
        <p:xfrm>
          <a:off x="1499574" y="7531969"/>
          <a:ext cx="3529626" cy="23799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15923013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73EA7BD5-6024-4DE7-9C40-8B9EF5BB299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01583054"/>
              </p:ext>
            </p:extLst>
          </p:nvPr>
        </p:nvGraphicFramePr>
        <p:xfrm>
          <a:off x="48147" y="990989"/>
          <a:ext cx="6772275" cy="44607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D5E45831-B1E7-440A-9075-48645BEE56F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46940872"/>
              </p:ext>
            </p:extLst>
          </p:nvPr>
        </p:nvGraphicFramePr>
        <p:xfrm>
          <a:off x="48148" y="5619749"/>
          <a:ext cx="6772274" cy="42862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itle 1">
            <a:extLst>
              <a:ext uri="{FF2B5EF4-FFF2-40B4-BE49-F238E27FC236}">
                <a16:creationId xmlns:a16="http://schemas.microsoft.com/office/drawing/2014/main" id="{3B354C3B-7F4B-43CF-9AF5-A4C0F9B8D4E6}"/>
              </a:ext>
            </a:extLst>
          </p:cNvPr>
          <p:cNvSpPr txBox="1">
            <a:spLocks/>
          </p:cNvSpPr>
          <p:nvPr/>
        </p:nvSpPr>
        <p:spPr>
          <a:xfrm>
            <a:off x="48147" y="89341"/>
            <a:ext cx="6375749" cy="733591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AU" sz="1400" b="1" dirty="0"/>
              <a:t>Supplementary Figure S2. </a:t>
            </a:r>
            <a:r>
              <a:rPr lang="en-AU" sz="1200" dirty="0"/>
              <a:t>Expression levels in BMDM derived from F2 brother sister mated birds.</a:t>
            </a:r>
            <a:br>
              <a:rPr lang="en-AU" sz="1200" dirty="0"/>
            </a:br>
            <a:r>
              <a:rPr lang="en-AU" sz="1200" dirty="0"/>
              <a:t> X axis shows the individual IDs; Y axis shows the expression level (TPM) before (black) and after (red) LPS treatment for paired samples.</a:t>
            </a:r>
            <a:endParaRPr lang="en-AU" sz="1200" b="1" dirty="0"/>
          </a:p>
        </p:txBody>
      </p:sp>
    </p:spTree>
    <p:extLst>
      <p:ext uri="{BB962C8B-B14F-4D97-AF65-F5344CB8AC3E}">
        <p14:creationId xmlns:p14="http://schemas.microsoft.com/office/powerpoint/2010/main" val="35932450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2BD88121-D97A-4428-B205-770D57F8811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4249361"/>
              </p:ext>
            </p:extLst>
          </p:nvPr>
        </p:nvGraphicFramePr>
        <p:xfrm>
          <a:off x="42862" y="666749"/>
          <a:ext cx="6772275" cy="42862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E452F1A9-28CD-473D-9C34-BBBEF0031CF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28996906"/>
              </p:ext>
            </p:extLst>
          </p:nvPr>
        </p:nvGraphicFramePr>
        <p:xfrm>
          <a:off x="42862" y="5363784"/>
          <a:ext cx="6772275" cy="42862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0492778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8E71E88F-9347-4F87-B1AF-F8FF510A023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63873483"/>
              </p:ext>
            </p:extLst>
          </p:nvPr>
        </p:nvGraphicFramePr>
        <p:xfrm>
          <a:off x="42862" y="5365183"/>
          <a:ext cx="6772275" cy="42862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1B229B7C-56D5-4E21-92E8-AA877F9DEE3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15009907"/>
              </p:ext>
            </p:extLst>
          </p:nvPr>
        </p:nvGraphicFramePr>
        <p:xfrm>
          <a:off x="85725" y="410784"/>
          <a:ext cx="6772275" cy="45422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258701253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EF1FFFB8-3054-47BD-8DD8-03021CF1173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70974640"/>
              </p:ext>
            </p:extLst>
          </p:nvPr>
        </p:nvGraphicFramePr>
        <p:xfrm>
          <a:off x="50104" y="304669"/>
          <a:ext cx="6772275" cy="42862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03CA5349-2460-4BBD-8769-AD96DEA5950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68608180"/>
              </p:ext>
            </p:extLst>
          </p:nvPr>
        </p:nvGraphicFramePr>
        <p:xfrm>
          <a:off x="42862" y="5242274"/>
          <a:ext cx="6772275" cy="42862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0246620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41</TotalTime>
  <Words>50</Words>
  <Application>Microsoft Macintosh PowerPoint</Application>
  <PresentationFormat>A4 Paper (210x297 mm)</PresentationFormat>
  <Paragraphs>18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im Summers</dc:creator>
  <cp:lastModifiedBy>David Hume</cp:lastModifiedBy>
  <cp:revision>68</cp:revision>
  <cp:lastPrinted>2019-04-11T05:00:44Z</cp:lastPrinted>
  <dcterms:created xsi:type="dcterms:W3CDTF">2019-03-13T00:15:48Z</dcterms:created>
  <dcterms:modified xsi:type="dcterms:W3CDTF">2019-07-01T06:46:34Z</dcterms:modified>
</cp:coreProperties>
</file>